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9" r:id="rId3"/>
    <p:sldId id="265" r:id="rId4"/>
    <p:sldId id="270" r:id="rId5"/>
    <p:sldId id="267" r:id="rId6"/>
    <p:sldId id="271" r:id="rId7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49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9435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7049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2747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56374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4980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9376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12727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27604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3990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422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3954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069079-3D01-4BA2-8577-12DBC54D0582}" type="datetimeFigureOut">
              <a:rPr lang="en-AU" smtClean="0"/>
              <a:t>18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404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48558" y="147241"/>
            <a:ext cx="1097953" cy="530915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AU" sz="570" b="1" dirty="0"/>
          </a:p>
          <a:p>
            <a:pPr algn="ctr"/>
            <a:r>
              <a:rPr lang="en-AU" sz="570" b="1" dirty="0"/>
              <a:t>Animals issued and allocated to groups: </a:t>
            </a:r>
            <a:r>
              <a:rPr lang="en-AU" sz="570" dirty="0"/>
              <a:t>(</a:t>
            </a:r>
            <a:r>
              <a:rPr lang="en-AU" sz="570" dirty="0" smtClean="0"/>
              <a:t>n=51) </a:t>
            </a:r>
            <a:endParaRPr lang="en-AU" sz="570" dirty="0"/>
          </a:p>
          <a:p>
            <a:pPr algn="ctr"/>
            <a:r>
              <a:rPr lang="en-AU" sz="570" dirty="0"/>
              <a:t>6 weeks old, male FVB/N mice</a:t>
            </a:r>
          </a:p>
          <a:p>
            <a:pPr algn="ctr"/>
            <a:endParaRPr lang="en-AU" sz="570" dirty="0"/>
          </a:p>
        </p:txBody>
      </p:sp>
      <p:sp>
        <p:nvSpPr>
          <p:cNvPr id="6" name="TextBox 5"/>
          <p:cNvSpPr txBox="1"/>
          <p:nvPr/>
        </p:nvSpPr>
        <p:spPr>
          <a:xfrm>
            <a:off x="4065873" y="722448"/>
            <a:ext cx="780136" cy="35548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AU" sz="570" b="1" dirty="0"/>
          </a:p>
          <a:p>
            <a:pPr algn="ctr"/>
            <a:r>
              <a:rPr lang="en-AU" sz="570" b="1" dirty="0"/>
              <a:t>Excluded: </a:t>
            </a:r>
            <a:r>
              <a:rPr lang="en-AU" sz="570" dirty="0"/>
              <a:t>(n=0) </a:t>
            </a:r>
          </a:p>
          <a:p>
            <a:endParaRPr lang="en-AU" sz="570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3297535" y="881261"/>
            <a:ext cx="76205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624457" y="1306447"/>
            <a:ext cx="2880000" cy="35548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Allocated </a:t>
            </a:r>
            <a:r>
              <a:rPr lang="en-AU" sz="570" b="1"/>
              <a:t>to </a:t>
            </a:r>
            <a:r>
              <a:rPr lang="en-AU" sz="570" b="1" smtClean="0"/>
              <a:t>T2D: </a:t>
            </a:r>
            <a:r>
              <a:rPr lang="en-AU" sz="570" dirty="0"/>
              <a:t>(</a:t>
            </a:r>
            <a:r>
              <a:rPr lang="en-AU" sz="570" dirty="0" smtClean="0"/>
              <a:t>n=36)</a:t>
            </a:r>
            <a:endParaRPr lang="en-AU" sz="570" dirty="0"/>
          </a:p>
          <a:p>
            <a:r>
              <a:rPr lang="en-AU" sz="570" b="1" dirty="0"/>
              <a:t>Received allocated intervention: </a:t>
            </a:r>
            <a:r>
              <a:rPr lang="en-AU" sz="570" dirty="0"/>
              <a:t>(</a:t>
            </a:r>
            <a:r>
              <a:rPr lang="en-AU" sz="570" dirty="0" smtClean="0"/>
              <a:t>n=36)</a:t>
            </a:r>
            <a:endParaRPr lang="en-AU" sz="570" dirty="0"/>
          </a:p>
          <a:p>
            <a:r>
              <a:rPr lang="en-AU" sz="570" b="1" dirty="0"/>
              <a:t>Did not receive allocated intervention: </a:t>
            </a:r>
            <a:r>
              <a:rPr lang="en-AU" sz="570" dirty="0"/>
              <a:t>(n=0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0247" y="1310974"/>
            <a:ext cx="2880000" cy="35548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Allocated to </a:t>
            </a:r>
            <a:r>
              <a:rPr lang="en-AU" sz="570" b="1" dirty="0" smtClean="0"/>
              <a:t>ND: </a:t>
            </a:r>
            <a:r>
              <a:rPr lang="en-AU" sz="570" dirty="0"/>
              <a:t>(n=15)</a:t>
            </a:r>
          </a:p>
          <a:p>
            <a:r>
              <a:rPr lang="en-AU" sz="570" b="1" dirty="0"/>
              <a:t>Received allocated intervention: </a:t>
            </a:r>
            <a:r>
              <a:rPr lang="en-AU" sz="570" dirty="0"/>
              <a:t>(n=15)</a:t>
            </a:r>
          </a:p>
          <a:p>
            <a:r>
              <a:rPr lang="en-AU" sz="570" b="1" dirty="0"/>
              <a:t>Did not receive allocated intervention: </a:t>
            </a:r>
            <a:r>
              <a:rPr lang="en-AU" sz="570" dirty="0"/>
              <a:t>(n=0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40247" y="1838817"/>
            <a:ext cx="2880000" cy="180049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Discontinued intervention: </a:t>
            </a:r>
            <a:r>
              <a:rPr lang="en-AU" sz="570" dirty="0" err="1"/>
              <a:t>Euthanised</a:t>
            </a:r>
            <a:r>
              <a:rPr lang="en-AU" sz="570" dirty="0"/>
              <a:t> due to ill health </a:t>
            </a:r>
            <a:r>
              <a:rPr lang="en-AU" sz="570" dirty="0" smtClean="0"/>
              <a:t>(fighting with littermates; n=1)</a:t>
            </a:r>
            <a:endParaRPr lang="en-AU" sz="570" dirty="0"/>
          </a:p>
        </p:txBody>
      </p:sp>
      <p:sp>
        <p:nvSpPr>
          <p:cNvPr id="18" name="TextBox 17"/>
          <p:cNvSpPr txBox="1"/>
          <p:nvPr/>
        </p:nvSpPr>
        <p:spPr>
          <a:xfrm>
            <a:off x="3624457" y="1832831"/>
            <a:ext cx="2880000" cy="180049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Discontinued intervention</a:t>
            </a:r>
            <a:r>
              <a:rPr lang="en-AU" sz="570" b="1" dirty="0" smtClean="0"/>
              <a:t>:</a:t>
            </a:r>
            <a:r>
              <a:rPr lang="en-AU" sz="570" dirty="0" smtClean="0"/>
              <a:t> </a:t>
            </a:r>
            <a:r>
              <a:rPr lang="en-AU" sz="570" dirty="0" err="1" smtClean="0"/>
              <a:t>Euthanised</a:t>
            </a:r>
            <a:r>
              <a:rPr lang="en-AU" sz="570" dirty="0" smtClean="0"/>
              <a:t> </a:t>
            </a:r>
            <a:r>
              <a:rPr lang="en-AU" sz="570" dirty="0"/>
              <a:t>due to </a:t>
            </a:r>
            <a:r>
              <a:rPr lang="en-AU" sz="570" dirty="0" smtClean="0"/>
              <a:t>ill health (diabetic complications; n=3)</a:t>
            </a:r>
            <a:endParaRPr lang="en-AU" sz="57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1800161" y="1127896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079218" y="1135718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805050" y="1138301"/>
            <a:ext cx="327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3297534" y="686094"/>
            <a:ext cx="0" cy="4455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1800161" y="1670831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5079218" y="1661929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40247" y="2549597"/>
            <a:ext cx="2880000" cy="6407908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Included in body, organ </a:t>
            </a:r>
            <a:r>
              <a:rPr lang="en-AU" sz="570" b="1" dirty="0" smtClean="0"/>
              <a:t>weight, </a:t>
            </a:r>
            <a:r>
              <a:rPr lang="en-AU" sz="570" b="1" dirty="0"/>
              <a:t>blood glucose </a:t>
            </a:r>
            <a:r>
              <a:rPr lang="en-AU" sz="570" b="1" dirty="0" smtClean="0"/>
              <a:t>and HbA1c measurements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</a:p>
          <a:p>
            <a:r>
              <a:rPr lang="en-AU" sz="570" b="1" dirty="0"/>
              <a:t>Data reported for body, organ weight, blood glucose and HbA1c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err="1" smtClean="0"/>
              <a:t>EchoMRI</a:t>
            </a:r>
            <a:r>
              <a:rPr lang="en-AU" sz="570" b="1" dirty="0" smtClean="0"/>
              <a:t> </a:t>
            </a:r>
            <a:r>
              <a:rPr lang="en-AU" sz="570" b="1" dirty="0"/>
              <a:t>measurements: </a:t>
            </a:r>
            <a:r>
              <a:rPr lang="en-AU" sz="570" dirty="0"/>
              <a:t>(n=14</a:t>
            </a:r>
            <a:r>
              <a:rPr lang="en-AU" sz="570" dirty="0" smtClean="0"/>
              <a:t>)</a:t>
            </a:r>
          </a:p>
          <a:p>
            <a:r>
              <a:rPr lang="en-AU" sz="570" b="1" dirty="0"/>
              <a:t>Data reported for </a:t>
            </a:r>
            <a:r>
              <a:rPr lang="en-AU" sz="570" b="1" dirty="0" err="1"/>
              <a:t>EchoMRI</a:t>
            </a:r>
            <a:r>
              <a:rPr lang="en-AU" sz="570" b="1" dirty="0"/>
              <a:t> </a:t>
            </a:r>
            <a:r>
              <a:rPr lang="en-AU" sz="570" b="1" dirty="0" smtClean="0"/>
              <a:t>measurements: </a:t>
            </a:r>
            <a:r>
              <a:rPr lang="en-AU" sz="570" dirty="0"/>
              <a:t>(n=14)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not </a:t>
            </a:r>
            <a:r>
              <a:rPr lang="en-AU" sz="570" b="1" dirty="0" smtClean="0"/>
              <a:t>reported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IPGTT measurements (18 and 26wks): </a:t>
            </a:r>
            <a:r>
              <a:rPr lang="en-AU" sz="570" dirty="0"/>
              <a:t>(n=14</a:t>
            </a:r>
            <a:r>
              <a:rPr lang="en-AU" sz="570" dirty="0" smtClean="0"/>
              <a:t>)</a:t>
            </a:r>
          </a:p>
          <a:p>
            <a:r>
              <a:rPr lang="en-AU" sz="570" b="1" dirty="0"/>
              <a:t>Data reported for IPGTT </a:t>
            </a:r>
            <a:r>
              <a:rPr lang="en-AU" sz="570" b="1" dirty="0" smtClean="0"/>
              <a:t>measurements (</a:t>
            </a:r>
            <a:r>
              <a:rPr lang="en-AU" sz="570" b="1" dirty="0"/>
              <a:t>18 and 26wks</a:t>
            </a:r>
            <a:r>
              <a:rPr lang="en-AU" sz="570" b="1" dirty="0" smtClean="0"/>
              <a:t>): </a:t>
            </a:r>
            <a:r>
              <a:rPr lang="en-AU" sz="570" dirty="0"/>
              <a:t>(n=14)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not </a:t>
            </a:r>
            <a:r>
              <a:rPr lang="en-AU" sz="570" b="1" dirty="0" smtClean="0"/>
              <a:t>reported: </a:t>
            </a:r>
            <a:r>
              <a:rPr lang="en-AU" sz="570" dirty="0"/>
              <a:t>(n=0</a:t>
            </a:r>
            <a:r>
              <a:rPr lang="en-AU" sz="570" dirty="0" smtClean="0"/>
              <a:t>)</a:t>
            </a:r>
            <a:endParaRPr lang="en-AU" sz="570" dirty="0" smtClean="0">
              <a:solidFill>
                <a:srgbClr val="FF0000"/>
              </a:solidFill>
            </a:endParaRPr>
          </a:p>
          <a:p>
            <a:r>
              <a:rPr lang="en-AU" sz="570" b="1" dirty="0"/>
              <a:t>Included in </a:t>
            </a:r>
            <a:r>
              <a:rPr lang="en-AU" sz="570" b="1" dirty="0" smtClean="0"/>
              <a:t>IPITT </a:t>
            </a:r>
            <a:r>
              <a:rPr lang="en-AU" sz="570" b="1" dirty="0"/>
              <a:t>measurements (</a:t>
            </a:r>
            <a:r>
              <a:rPr lang="en-AU" sz="570" b="1" dirty="0" smtClean="0"/>
              <a:t>18wks</a:t>
            </a:r>
            <a:r>
              <a:rPr lang="en-AU" sz="570" b="1" dirty="0"/>
              <a:t>)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IPITT </a:t>
            </a:r>
            <a:r>
              <a:rPr lang="en-AU" sz="570" b="1" dirty="0"/>
              <a:t>measurements (</a:t>
            </a:r>
            <a:r>
              <a:rPr lang="en-AU" sz="570" b="1" dirty="0" smtClean="0"/>
              <a:t>18wks</a:t>
            </a:r>
            <a:r>
              <a:rPr lang="en-AU" sz="570" b="1" dirty="0"/>
              <a:t>): </a:t>
            </a:r>
            <a:r>
              <a:rPr lang="en-AU" sz="570" dirty="0"/>
              <a:t>(</a:t>
            </a:r>
            <a:r>
              <a:rPr lang="en-AU" sz="570" dirty="0" smtClean="0"/>
              <a:t>n=11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</a:t>
            </a:r>
            <a:r>
              <a:rPr lang="en-AU" sz="570" dirty="0" smtClean="0"/>
              <a:t>n=3)</a:t>
            </a:r>
          </a:p>
          <a:p>
            <a:r>
              <a:rPr lang="en-AU" sz="570" b="1" dirty="0" smtClean="0"/>
              <a:t>Reasons: </a:t>
            </a:r>
            <a:r>
              <a:rPr lang="en-AU" sz="570" dirty="0"/>
              <a:t>One mouse became hypoglycaemic mid-experiment</a:t>
            </a:r>
            <a:r>
              <a:rPr lang="en-AU" sz="570" dirty="0" smtClean="0"/>
              <a:t>. Two mice exhibited an unusual response to insulin (increased blood glucose – possible stress response).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IPITT measurements </a:t>
            </a:r>
            <a:r>
              <a:rPr lang="en-AU" sz="570" b="1" dirty="0" smtClean="0"/>
              <a:t>(26wks</a:t>
            </a:r>
            <a:r>
              <a:rPr lang="en-AU" sz="570" b="1" dirty="0"/>
              <a:t>)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 for IPITT measurements </a:t>
            </a:r>
            <a:r>
              <a:rPr lang="en-AU" sz="570" b="1" dirty="0" smtClean="0"/>
              <a:t>(26ks</a:t>
            </a:r>
            <a:r>
              <a:rPr lang="en-AU" sz="570" b="1" dirty="0"/>
              <a:t>): </a:t>
            </a:r>
            <a:r>
              <a:rPr lang="en-AU" sz="570" dirty="0"/>
              <a:t>(</a:t>
            </a:r>
            <a:r>
              <a:rPr lang="en-AU" sz="570" dirty="0" smtClean="0"/>
              <a:t>n=12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</a:t>
            </a:r>
            <a:r>
              <a:rPr lang="en-AU" sz="570" dirty="0" smtClean="0"/>
              <a:t>n=2)</a:t>
            </a:r>
            <a:endParaRPr lang="en-AU" sz="570" dirty="0"/>
          </a:p>
          <a:p>
            <a:r>
              <a:rPr lang="en-AU" sz="570" b="1" dirty="0" smtClean="0"/>
              <a:t>Reason: </a:t>
            </a:r>
            <a:r>
              <a:rPr lang="en-AU" sz="570" dirty="0" smtClean="0"/>
              <a:t>(Same) two </a:t>
            </a:r>
            <a:r>
              <a:rPr lang="en-AU" sz="570" dirty="0"/>
              <a:t>mice </a:t>
            </a:r>
            <a:r>
              <a:rPr lang="en-AU" sz="570" dirty="0" smtClean="0"/>
              <a:t>exhibited </a:t>
            </a:r>
            <a:r>
              <a:rPr lang="en-AU" sz="570" dirty="0"/>
              <a:t>an unusual </a:t>
            </a:r>
            <a:r>
              <a:rPr lang="en-AU" sz="570" dirty="0" smtClean="0"/>
              <a:t>response </a:t>
            </a:r>
            <a:r>
              <a:rPr lang="en-AU" sz="570" dirty="0"/>
              <a:t>to insulin </a:t>
            </a:r>
            <a:r>
              <a:rPr lang="en-AU" sz="570" dirty="0" smtClean="0"/>
              <a:t>(increased blood glucose - possible </a:t>
            </a:r>
            <a:r>
              <a:rPr lang="en-AU" sz="570" dirty="0"/>
              <a:t>stress response).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metabolic caging </a:t>
            </a:r>
            <a:r>
              <a:rPr lang="en-AU" sz="570" b="1" dirty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10)</a:t>
            </a:r>
          </a:p>
          <a:p>
            <a:r>
              <a:rPr lang="en-AU" sz="570" b="1" dirty="0" smtClean="0"/>
              <a:t>Reason: </a:t>
            </a:r>
            <a:r>
              <a:rPr lang="en-AU" sz="570" dirty="0" smtClean="0"/>
              <a:t>Subset of animals measured due to equipment availability.</a:t>
            </a:r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metabolic caging measurements: </a:t>
            </a:r>
            <a:r>
              <a:rPr lang="en-AU" sz="570" dirty="0"/>
              <a:t>(</a:t>
            </a:r>
            <a:r>
              <a:rPr lang="en-AU" sz="570" dirty="0" smtClean="0"/>
              <a:t>n=10)</a:t>
            </a:r>
            <a:endParaRPr lang="en-AU" sz="570" dirty="0"/>
          </a:p>
          <a:p>
            <a:r>
              <a:rPr lang="en-AU" sz="570" b="1" dirty="0" smtClean="0"/>
              <a:t>Data </a:t>
            </a:r>
            <a:r>
              <a:rPr lang="en-AU" sz="570" b="1" dirty="0"/>
              <a:t>not </a:t>
            </a:r>
            <a:r>
              <a:rPr lang="en-AU" sz="570" b="1" dirty="0" smtClean="0"/>
              <a:t>reported: </a:t>
            </a:r>
            <a:r>
              <a:rPr lang="en-AU" sz="570" dirty="0"/>
              <a:t>(n=0)</a:t>
            </a:r>
          </a:p>
          <a:p>
            <a:endParaRPr lang="en-AU" sz="570" dirty="0" smtClean="0">
              <a:solidFill>
                <a:srgbClr val="FF0000"/>
              </a:solidFill>
            </a:endParaRPr>
          </a:p>
          <a:p>
            <a:endParaRPr lang="en-AU" sz="570" b="1" dirty="0" smtClean="0">
              <a:solidFill>
                <a:srgbClr val="FF0000"/>
              </a:solidFill>
            </a:endParaRPr>
          </a:p>
          <a:p>
            <a:endParaRPr lang="en-AU" sz="570" b="1" dirty="0">
              <a:solidFill>
                <a:srgbClr val="FF0000"/>
              </a:solidFill>
            </a:endParaRP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insulin ELISA </a:t>
            </a:r>
            <a:r>
              <a:rPr lang="en-AU" sz="570" b="1" dirty="0"/>
              <a:t>measurements: </a:t>
            </a:r>
            <a:r>
              <a:rPr lang="en-AU" sz="570" dirty="0"/>
              <a:t>(n=10)</a:t>
            </a:r>
          </a:p>
          <a:p>
            <a:r>
              <a:rPr lang="en-AU" sz="570" b="1" dirty="0"/>
              <a:t>Reason: </a:t>
            </a:r>
            <a:r>
              <a:rPr lang="en-AU" sz="570" dirty="0" smtClean="0"/>
              <a:t>Measured in a </a:t>
            </a:r>
            <a:r>
              <a:rPr lang="en-AU" sz="570" dirty="0"/>
              <a:t>s</a:t>
            </a:r>
            <a:r>
              <a:rPr lang="en-AU" sz="570" dirty="0" smtClean="0"/>
              <a:t>ubset </a:t>
            </a:r>
            <a:r>
              <a:rPr lang="en-AU" sz="570" dirty="0"/>
              <a:t>of animals </a:t>
            </a:r>
            <a:r>
              <a:rPr lang="en-AU" sz="570" dirty="0" smtClean="0"/>
              <a:t>for logistical reasons (plate size).</a:t>
            </a:r>
            <a:endParaRPr lang="en-AU" sz="570" dirty="0"/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insulin ELISA measurements: </a:t>
            </a:r>
            <a:r>
              <a:rPr lang="en-AU" sz="570" dirty="0"/>
              <a:t>(</a:t>
            </a:r>
            <a:r>
              <a:rPr lang="en-AU" sz="570" dirty="0" smtClean="0"/>
              <a:t>n=9)</a:t>
            </a:r>
            <a:endParaRPr lang="en-AU" sz="570" dirty="0"/>
          </a:p>
          <a:p>
            <a:r>
              <a:rPr lang="en-AU" sz="570" b="1" dirty="0" smtClean="0"/>
              <a:t>Data not reported: </a:t>
            </a:r>
            <a:r>
              <a:rPr lang="en-AU" sz="570" dirty="0" smtClean="0"/>
              <a:t>(n=1)</a:t>
            </a:r>
          </a:p>
          <a:p>
            <a:r>
              <a:rPr lang="en-AU" sz="570" b="1" dirty="0" smtClean="0"/>
              <a:t>Reason: </a:t>
            </a:r>
            <a:r>
              <a:rPr lang="en-AU" sz="570" dirty="0" smtClean="0"/>
              <a:t>Extreme outlier excluded as value greater than the upper quartile plus 3*interquartile range.</a:t>
            </a:r>
            <a:endParaRPr lang="en-AU" sz="570" dirty="0" smtClean="0">
              <a:solidFill>
                <a:srgbClr val="FF0000"/>
              </a:solidFill>
            </a:endParaRPr>
          </a:p>
          <a:p>
            <a:r>
              <a:rPr lang="en-AU" sz="570" b="1" dirty="0" smtClean="0"/>
              <a:t>Included in C-peptide ELISA measurements: </a:t>
            </a:r>
            <a:r>
              <a:rPr lang="en-AU" sz="570" dirty="0" smtClean="0"/>
              <a:t>(n=14)</a:t>
            </a:r>
            <a:r>
              <a:rPr lang="en-AU" sz="570" b="1" dirty="0" smtClean="0"/>
              <a:t> 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</a:t>
            </a:r>
            <a:r>
              <a:rPr lang="en-AU" sz="570" b="1" dirty="0" smtClean="0"/>
              <a:t>for </a:t>
            </a:r>
            <a:r>
              <a:rPr lang="en-AU" sz="570" b="1" dirty="0"/>
              <a:t> </a:t>
            </a:r>
            <a:r>
              <a:rPr lang="en-AU" sz="570" b="1" dirty="0" smtClean="0"/>
              <a:t>C-peptide measurements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n=0)</a:t>
            </a:r>
          </a:p>
          <a:p>
            <a:endParaRPr lang="en-AU" sz="570" dirty="0" smtClean="0">
              <a:solidFill>
                <a:srgbClr val="FF0000"/>
              </a:solidFill>
            </a:endParaRPr>
          </a:p>
          <a:p>
            <a:endParaRPr lang="en-AU" sz="570" dirty="0">
              <a:solidFill>
                <a:srgbClr val="FF0000"/>
              </a:solidFill>
            </a:endParaRP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LV real-time </a:t>
            </a:r>
            <a:r>
              <a:rPr lang="en-AU" sz="570" b="1" dirty="0"/>
              <a:t>qPCR measurements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</a:t>
            </a:r>
            <a:r>
              <a:rPr lang="en-AU" sz="570" b="1" dirty="0" smtClean="0"/>
              <a:t>LV real-time </a:t>
            </a:r>
            <a:r>
              <a:rPr lang="en-AU" sz="570" b="1" dirty="0"/>
              <a:t>qPCR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LV real-time qPCR: </a:t>
            </a:r>
            <a:r>
              <a:rPr lang="en-AU" sz="570" dirty="0" smtClean="0"/>
              <a:t>(n=0)</a:t>
            </a:r>
            <a:endParaRPr lang="en-AU" sz="570" dirty="0"/>
          </a:p>
          <a:p>
            <a:endParaRPr lang="en-AU" sz="570" dirty="0" smtClean="0">
              <a:solidFill>
                <a:srgbClr val="FF0000"/>
              </a:solidFill>
            </a:endParaRP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week 26 echocardiography measurements:</a:t>
            </a:r>
            <a:r>
              <a:rPr lang="en-AU" sz="570" dirty="0" smtClean="0"/>
              <a:t>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</a:t>
            </a:r>
            <a:r>
              <a:rPr lang="en-AU" sz="570" b="1" dirty="0" smtClean="0"/>
              <a:t>week 26 M-mode echocardiography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week 26 M-mode echocardiography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Data reported for week 26 Doppler echocardiography: </a:t>
            </a:r>
            <a:r>
              <a:rPr lang="en-AU" sz="570" dirty="0" smtClean="0"/>
              <a:t>(n=14)</a:t>
            </a:r>
          </a:p>
          <a:p>
            <a:r>
              <a:rPr lang="en-AU" sz="570" b="1" dirty="0" smtClean="0"/>
              <a:t>Data not reported for week 26 Doppler echocardiography: </a:t>
            </a:r>
            <a:r>
              <a:rPr lang="en-AU" sz="570" dirty="0" smtClean="0"/>
              <a:t>(n=0)</a:t>
            </a:r>
            <a:endParaRPr lang="en-AU" sz="570" dirty="0"/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week 26 tissue Doppler echocardiography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week 26 tissue Doppler echocardiography: </a:t>
            </a:r>
            <a:r>
              <a:rPr lang="en-AU" sz="570" dirty="0"/>
              <a:t>(n=0)</a:t>
            </a:r>
          </a:p>
          <a:p>
            <a:endParaRPr lang="en-AU" sz="570" dirty="0" smtClean="0">
              <a:solidFill>
                <a:srgbClr val="FF0000"/>
              </a:solidFill>
            </a:endParaRPr>
          </a:p>
          <a:p>
            <a:r>
              <a:rPr lang="en-AU" sz="570" b="1" dirty="0"/>
              <a:t>Included in </a:t>
            </a:r>
            <a:r>
              <a:rPr lang="en-AU" sz="570" b="1" dirty="0" smtClean="0"/>
              <a:t>baseline and week 18 </a:t>
            </a:r>
            <a:r>
              <a:rPr lang="en-AU" sz="570" b="1" dirty="0"/>
              <a:t>echocardiography measurements:</a:t>
            </a:r>
            <a:r>
              <a:rPr lang="en-AU" sz="570" dirty="0"/>
              <a:t> (</a:t>
            </a:r>
            <a:r>
              <a:rPr lang="en-AU" sz="570" dirty="0" smtClean="0"/>
              <a:t>n=6)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Subset of animals measured due to practical reasons.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baseline and week 18</a:t>
            </a:r>
            <a:r>
              <a:rPr lang="en-AU" sz="570" b="1" dirty="0" smtClean="0"/>
              <a:t> </a:t>
            </a:r>
            <a:r>
              <a:rPr lang="en-AU" sz="570" b="1" dirty="0"/>
              <a:t>M-mode </a:t>
            </a:r>
            <a:r>
              <a:rPr lang="en-AU" sz="570" b="1" dirty="0" smtClean="0"/>
              <a:t>echocardiography: </a:t>
            </a:r>
            <a:r>
              <a:rPr lang="en-AU" sz="570" dirty="0"/>
              <a:t>(</a:t>
            </a:r>
            <a:r>
              <a:rPr lang="en-AU" sz="570" dirty="0" smtClean="0"/>
              <a:t>n=6)</a:t>
            </a:r>
            <a:endParaRPr lang="en-AU" sz="570" dirty="0"/>
          </a:p>
          <a:p>
            <a:r>
              <a:rPr lang="en-AU" sz="570" b="1" dirty="0"/>
              <a:t>Data not reported for baseline and week 18</a:t>
            </a:r>
            <a:r>
              <a:rPr lang="en-AU" sz="570" b="1" dirty="0" smtClean="0"/>
              <a:t> </a:t>
            </a:r>
            <a:r>
              <a:rPr lang="en-AU" sz="570" b="1" dirty="0"/>
              <a:t>M-mode </a:t>
            </a:r>
            <a:r>
              <a:rPr lang="en-AU" sz="570" b="1" dirty="0" smtClean="0"/>
              <a:t>echocardiography: </a:t>
            </a:r>
            <a:r>
              <a:rPr lang="en-AU" sz="570" dirty="0"/>
              <a:t>(n=0)</a:t>
            </a:r>
          </a:p>
          <a:p>
            <a:r>
              <a:rPr lang="en-AU" sz="570" b="1" dirty="0"/>
              <a:t>Data reported for baseline and week 18</a:t>
            </a:r>
            <a:r>
              <a:rPr lang="en-AU" sz="570" b="1" dirty="0" smtClean="0"/>
              <a:t> </a:t>
            </a:r>
            <a:r>
              <a:rPr lang="en-AU" sz="570" b="1" dirty="0"/>
              <a:t>Doppler </a:t>
            </a:r>
            <a:r>
              <a:rPr lang="en-AU" sz="570" b="1" dirty="0" smtClean="0"/>
              <a:t>echocardiography: </a:t>
            </a:r>
            <a:r>
              <a:rPr lang="en-AU" sz="570" dirty="0"/>
              <a:t>(</a:t>
            </a:r>
            <a:r>
              <a:rPr lang="en-AU" sz="570" dirty="0" smtClean="0"/>
              <a:t>n=6)</a:t>
            </a:r>
            <a:endParaRPr lang="en-AU" sz="570" dirty="0"/>
          </a:p>
          <a:p>
            <a:r>
              <a:rPr lang="en-AU" sz="570" b="1" dirty="0"/>
              <a:t>Data not reported for baseline and week 18</a:t>
            </a:r>
            <a:r>
              <a:rPr lang="en-AU" sz="570" b="1" dirty="0" smtClean="0"/>
              <a:t> </a:t>
            </a:r>
            <a:r>
              <a:rPr lang="en-AU" sz="570" b="1" dirty="0"/>
              <a:t>Doppler </a:t>
            </a:r>
            <a:r>
              <a:rPr lang="en-AU" sz="570" b="1" dirty="0" smtClean="0"/>
              <a:t>echocardiography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western blotting </a:t>
            </a:r>
            <a:r>
              <a:rPr lang="en-AU" sz="570" b="1" dirty="0"/>
              <a:t>measurements: </a:t>
            </a:r>
            <a:r>
              <a:rPr lang="en-AU" sz="570" dirty="0"/>
              <a:t>(n=6)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Subset of animals measured due to </a:t>
            </a:r>
            <a:r>
              <a:rPr lang="en-AU" sz="570" dirty="0" smtClean="0"/>
              <a:t>sample availability.</a:t>
            </a:r>
            <a:endParaRPr lang="en-AU" sz="570" dirty="0"/>
          </a:p>
          <a:p>
            <a:r>
              <a:rPr lang="en-AU" sz="570" b="1" dirty="0"/>
              <a:t>Data reported </a:t>
            </a:r>
            <a:r>
              <a:rPr lang="en-AU" sz="570" b="1" dirty="0" smtClean="0"/>
              <a:t>for western blotting measurements: </a:t>
            </a:r>
            <a:r>
              <a:rPr lang="en-AU" sz="570" dirty="0"/>
              <a:t>(n=6)</a:t>
            </a:r>
          </a:p>
          <a:p>
            <a:r>
              <a:rPr lang="en-AU" sz="570" b="1" dirty="0"/>
              <a:t>Data not reported </a:t>
            </a:r>
            <a:r>
              <a:rPr lang="en-AU" sz="570" b="1" dirty="0" smtClean="0"/>
              <a:t>for </a:t>
            </a:r>
            <a:r>
              <a:rPr lang="en-AU" sz="570" b="1" dirty="0"/>
              <a:t>western blotting </a:t>
            </a:r>
            <a:r>
              <a:rPr lang="en-AU" sz="570" b="1" dirty="0" smtClean="0"/>
              <a:t>measurements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mesangial expansion </a:t>
            </a:r>
            <a:r>
              <a:rPr lang="en-AU" sz="570" b="1" dirty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mesangial expansion</a:t>
            </a:r>
            <a:r>
              <a:rPr lang="en-AU" sz="570" b="1" dirty="0" smtClean="0"/>
              <a:t> measurements: </a:t>
            </a:r>
            <a:r>
              <a:rPr lang="en-AU" sz="570" dirty="0"/>
              <a:t>(</a:t>
            </a:r>
            <a:r>
              <a:rPr lang="en-AU" sz="570" dirty="0" smtClean="0"/>
              <a:t>n=13)</a:t>
            </a:r>
            <a:endParaRPr lang="en-AU" sz="570" dirty="0"/>
          </a:p>
          <a:p>
            <a:r>
              <a:rPr lang="en-AU" sz="570" b="1" dirty="0"/>
              <a:t>Data not reported for mesangial </a:t>
            </a:r>
            <a:r>
              <a:rPr lang="en-AU" sz="570" b="1" dirty="0" smtClean="0"/>
              <a:t>expansion: </a:t>
            </a:r>
            <a:r>
              <a:rPr lang="en-AU" sz="570" dirty="0" smtClean="0"/>
              <a:t>(n=1)</a:t>
            </a:r>
          </a:p>
          <a:p>
            <a:r>
              <a:rPr lang="en-AU" sz="570" b="1" dirty="0" smtClean="0"/>
              <a:t>Reason: </a:t>
            </a:r>
            <a:r>
              <a:rPr lang="en-AU" sz="570" dirty="0" smtClean="0"/>
              <a:t>Problem with tissue processing prior to staining.</a:t>
            </a:r>
            <a:endParaRPr lang="en-AU" sz="570" dirty="0"/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kidney </a:t>
            </a:r>
            <a:r>
              <a:rPr lang="en-AU" sz="570" b="1" dirty="0"/>
              <a:t>real-time qPCR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kidney </a:t>
            </a:r>
            <a:r>
              <a:rPr lang="en-AU" sz="570" b="1" dirty="0"/>
              <a:t>real-time qPCR </a:t>
            </a:r>
            <a:r>
              <a:rPr lang="en-AU" sz="570" b="1" dirty="0" smtClean="0"/>
              <a:t>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kidney </a:t>
            </a:r>
            <a:r>
              <a:rPr lang="en-AU" sz="570" b="1" dirty="0"/>
              <a:t>real-time </a:t>
            </a:r>
            <a:r>
              <a:rPr lang="en-AU" sz="570" b="1" dirty="0" smtClean="0"/>
              <a:t>qPCR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albumin </a:t>
            </a:r>
            <a:r>
              <a:rPr lang="en-AU" sz="570" b="1" dirty="0"/>
              <a:t>ELISA measurements: </a:t>
            </a:r>
            <a:r>
              <a:rPr lang="en-AU" sz="570" dirty="0"/>
              <a:t>(</a:t>
            </a:r>
            <a:r>
              <a:rPr lang="en-AU" sz="570" dirty="0" smtClean="0"/>
              <a:t>n=9)</a:t>
            </a:r>
            <a:r>
              <a:rPr lang="en-AU" sz="570" b="1" dirty="0" smtClean="0"/>
              <a:t> </a:t>
            </a:r>
            <a:endParaRPr lang="en-AU" sz="570" b="1" dirty="0"/>
          </a:p>
          <a:p>
            <a:r>
              <a:rPr lang="en-AU" sz="570" b="1" dirty="0"/>
              <a:t>Reason: </a:t>
            </a:r>
            <a:r>
              <a:rPr lang="en-AU" sz="570" dirty="0"/>
              <a:t>Subset of animals measured due to practical reasons.</a:t>
            </a:r>
          </a:p>
          <a:p>
            <a:r>
              <a:rPr lang="en-AU" sz="570" b="1" dirty="0"/>
              <a:t>Data reported for  C-peptide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9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n=0</a:t>
            </a:r>
            <a:r>
              <a:rPr lang="en-AU" sz="570" dirty="0" smtClean="0"/>
              <a:t>)</a:t>
            </a:r>
          </a:p>
          <a:p>
            <a:endParaRPr lang="en-AU" sz="570" dirty="0"/>
          </a:p>
          <a:p>
            <a:endParaRPr lang="en-AU" sz="570" dirty="0" smtClean="0"/>
          </a:p>
        </p:txBody>
      </p:sp>
      <p:sp>
        <p:nvSpPr>
          <p:cNvPr id="47" name="TextBox 46"/>
          <p:cNvSpPr txBox="1"/>
          <p:nvPr/>
        </p:nvSpPr>
        <p:spPr>
          <a:xfrm>
            <a:off x="3624456" y="2549597"/>
            <a:ext cx="2871037" cy="6407908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Included in body, organ </a:t>
            </a:r>
            <a:r>
              <a:rPr lang="en-AU" sz="570" b="1" dirty="0" smtClean="0"/>
              <a:t>weight, </a:t>
            </a:r>
            <a:r>
              <a:rPr lang="en-AU" sz="570" b="1" dirty="0"/>
              <a:t>blood glucose </a:t>
            </a:r>
            <a:r>
              <a:rPr lang="en-AU" sz="570" b="1" dirty="0" smtClean="0"/>
              <a:t>and HbA1c 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reported for body, organ weight, blood glucose and HbA1c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not </a:t>
            </a:r>
            <a:r>
              <a:rPr lang="en-AU" sz="570" b="1" dirty="0" smtClean="0"/>
              <a:t>reported: </a:t>
            </a:r>
            <a:r>
              <a:rPr lang="en-AU" sz="570" dirty="0"/>
              <a:t>(n=0</a:t>
            </a:r>
            <a:r>
              <a:rPr lang="en-AU" sz="570" dirty="0" smtClean="0"/>
              <a:t>)</a:t>
            </a:r>
            <a:endParaRPr lang="en-AU" sz="570" dirty="0">
              <a:solidFill>
                <a:srgbClr val="FF0000"/>
              </a:solidFill>
            </a:endParaRPr>
          </a:p>
          <a:p>
            <a:r>
              <a:rPr lang="en-AU" sz="570" b="1" dirty="0"/>
              <a:t>Included in </a:t>
            </a:r>
            <a:r>
              <a:rPr lang="en-AU" sz="570" b="1" dirty="0" err="1"/>
              <a:t>EchoMRI</a:t>
            </a:r>
            <a:r>
              <a:rPr lang="en-AU" sz="570" b="1" dirty="0"/>
              <a:t> 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</a:p>
          <a:p>
            <a:r>
              <a:rPr lang="en-AU" sz="570" b="1" dirty="0"/>
              <a:t>Data reported for </a:t>
            </a:r>
            <a:r>
              <a:rPr lang="en-AU" sz="570" b="1" dirty="0" err="1"/>
              <a:t>EchoMRI</a:t>
            </a:r>
            <a:r>
              <a:rPr lang="en-AU" sz="570" b="1" dirty="0"/>
              <a:t>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 smtClean="0"/>
              <a:t>Data </a:t>
            </a:r>
            <a:r>
              <a:rPr lang="en-AU" sz="570" b="1" dirty="0"/>
              <a:t>not </a:t>
            </a:r>
            <a:r>
              <a:rPr lang="en-AU" sz="570" b="1" dirty="0" smtClean="0"/>
              <a:t>reported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IPGTT measurements (18 and 26wks)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reported for IPGTT measurements (18 and 26wks)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not reported </a:t>
            </a:r>
            <a:r>
              <a:rPr lang="en-AU" sz="570" dirty="0"/>
              <a:t>(n=0</a:t>
            </a:r>
            <a:r>
              <a:rPr lang="en-AU" sz="570" dirty="0" smtClean="0"/>
              <a:t>)</a:t>
            </a:r>
            <a:endParaRPr lang="en-AU" sz="570" dirty="0" smtClean="0">
              <a:solidFill>
                <a:srgbClr val="FF0000"/>
              </a:solidFill>
            </a:endParaRPr>
          </a:p>
          <a:p>
            <a:r>
              <a:rPr lang="en-AU" sz="570" b="1" dirty="0"/>
              <a:t>Included in IPITT measurements (18wks)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reported for IPITT measurements (18wks)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not reported </a:t>
            </a:r>
            <a:r>
              <a:rPr lang="en-AU" sz="570" dirty="0"/>
              <a:t>(</a:t>
            </a:r>
            <a:r>
              <a:rPr lang="en-AU" sz="570" dirty="0" smtClean="0"/>
              <a:t>n=0)</a:t>
            </a:r>
            <a:endParaRPr lang="en-AU" sz="570" dirty="0"/>
          </a:p>
          <a:p>
            <a:endParaRPr lang="en-AU" sz="570" dirty="0" smtClean="0">
              <a:solidFill>
                <a:srgbClr val="FF0000"/>
              </a:solidFill>
            </a:endParaRPr>
          </a:p>
          <a:p>
            <a:endParaRPr lang="en-AU" sz="570" b="1" dirty="0" smtClean="0"/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IPITT measurements (26wks)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reported for IPITT measurements (26ks): </a:t>
            </a:r>
            <a:r>
              <a:rPr lang="en-AU" sz="570" dirty="0"/>
              <a:t>(</a:t>
            </a:r>
            <a:r>
              <a:rPr lang="en-AU" sz="570" dirty="0" smtClean="0"/>
              <a:t>n=32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</a:t>
            </a:r>
            <a:r>
              <a:rPr lang="en-AU" sz="570" dirty="0" smtClean="0"/>
              <a:t>n=1)</a:t>
            </a:r>
            <a:endParaRPr lang="en-AU" sz="570" dirty="0"/>
          </a:p>
          <a:p>
            <a:r>
              <a:rPr lang="en-AU" sz="570" b="1" dirty="0" smtClean="0"/>
              <a:t>Reason: </a:t>
            </a:r>
            <a:r>
              <a:rPr lang="en-AU" sz="570" dirty="0"/>
              <a:t>One mouse </a:t>
            </a:r>
            <a:r>
              <a:rPr lang="en-AU" sz="570" dirty="0" smtClean="0"/>
              <a:t>became </a:t>
            </a:r>
            <a:r>
              <a:rPr lang="en-AU" sz="570" dirty="0"/>
              <a:t>hypoglycaemic </a:t>
            </a:r>
            <a:r>
              <a:rPr lang="en-AU" sz="570" dirty="0" smtClean="0"/>
              <a:t>mid-experiment</a:t>
            </a:r>
            <a:r>
              <a:rPr lang="en-AU" sz="570" dirty="0"/>
              <a:t>. </a:t>
            </a:r>
            <a:endParaRPr lang="en-AU" sz="570" b="1" dirty="0" smtClean="0"/>
          </a:p>
          <a:p>
            <a:endParaRPr lang="en-AU" sz="570" b="1" dirty="0" smtClean="0"/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metabolic caging measurements: </a:t>
            </a:r>
            <a:r>
              <a:rPr lang="en-AU" sz="570" dirty="0"/>
              <a:t>(</a:t>
            </a:r>
            <a:r>
              <a:rPr lang="en-AU" sz="570" dirty="0" smtClean="0"/>
              <a:t>n=16)</a:t>
            </a:r>
            <a:endParaRPr lang="en-AU" sz="570" dirty="0"/>
          </a:p>
          <a:p>
            <a:r>
              <a:rPr lang="en-AU" sz="570" b="1" dirty="0"/>
              <a:t>Reason: </a:t>
            </a:r>
            <a:r>
              <a:rPr lang="en-AU" sz="570" dirty="0"/>
              <a:t>Subset of animals measured due to equipment </a:t>
            </a:r>
            <a:r>
              <a:rPr lang="en-AU" sz="570" dirty="0" smtClean="0"/>
              <a:t>availability.</a:t>
            </a:r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water consumption measurements: </a:t>
            </a:r>
            <a:r>
              <a:rPr lang="en-AU" sz="570" dirty="0"/>
              <a:t>(</a:t>
            </a:r>
            <a:r>
              <a:rPr lang="en-AU" sz="570" dirty="0" smtClean="0"/>
              <a:t>n=15)</a:t>
            </a:r>
            <a:endParaRPr lang="en-AU" sz="570" dirty="0"/>
          </a:p>
          <a:p>
            <a:r>
              <a:rPr lang="en-AU" sz="570" b="1" dirty="0" smtClean="0"/>
              <a:t>Data </a:t>
            </a:r>
            <a:r>
              <a:rPr lang="en-AU" sz="570" b="1" dirty="0"/>
              <a:t>not </a:t>
            </a:r>
            <a:r>
              <a:rPr lang="en-AU" sz="570" b="1" dirty="0" smtClean="0"/>
              <a:t>reported: </a:t>
            </a:r>
            <a:r>
              <a:rPr lang="en-AU" sz="570" dirty="0"/>
              <a:t>(</a:t>
            </a:r>
            <a:r>
              <a:rPr lang="en-AU" sz="570" dirty="0" smtClean="0"/>
              <a:t>n=1)</a:t>
            </a:r>
          </a:p>
          <a:p>
            <a:r>
              <a:rPr lang="en-AU" sz="570" b="1" dirty="0" smtClean="0"/>
              <a:t>Reason:</a:t>
            </a:r>
            <a:r>
              <a:rPr lang="en-AU" sz="570" dirty="0" smtClean="0"/>
              <a:t> Data recording error.</a:t>
            </a:r>
            <a:endParaRPr lang="en-AU" sz="570" dirty="0"/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food </a:t>
            </a:r>
            <a:r>
              <a:rPr lang="en-AU" sz="570" b="1" dirty="0"/>
              <a:t>consumption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16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</a:t>
            </a:r>
            <a:r>
              <a:rPr lang="en-AU" sz="570" dirty="0" smtClean="0"/>
              <a:t>n=0)</a:t>
            </a:r>
            <a:endParaRPr lang="en-AU" sz="570" dirty="0"/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insulin ELISA measurements: </a:t>
            </a:r>
            <a:r>
              <a:rPr lang="en-AU" sz="570" dirty="0"/>
              <a:t>(</a:t>
            </a:r>
            <a:r>
              <a:rPr lang="en-AU" sz="570" dirty="0" smtClean="0"/>
              <a:t>n=28)</a:t>
            </a:r>
            <a:endParaRPr lang="en-AU" sz="570" dirty="0"/>
          </a:p>
          <a:p>
            <a:r>
              <a:rPr lang="en-AU" sz="570" b="1" dirty="0"/>
              <a:t>Reason: </a:t>
            </a:r>
            <a:r>
              <a:rPr lang="en-AU" sz="570" dirty="0"/>
              <a:t>Measured in a subset of animals for logistical reasons (plate size).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metabolic caging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27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</a:t>
            </a:r>
            <a:r>
              <a:rPr lang="en-AU" sz="570" dirty="0" smtClean="0"/>
              <a:t>n=1)</a:t>
            </a:r>
            <a:endParaRPr lang="en-AU" sz="570" dirty="0"/>
          </a:p>
          <a:p>
            <a:r>
              <a:rPr lang="en-AU" sz="570" b="1" dirty="0"/>
              <a:t>Reason: </a:t>
            </a:r>
            <a:r>
              <a:rPr lang="en-AU" sz="570" dirty="0"/>
              <a:t>Extreme outlier excluded as value greater than the upper quartile plus 3*interquartile range.</a:t>
            </a:r>
            <a:endParaRPr lang="en-AU" sz="570" dirty="0">
              <a:solidFill>
                <a:srgbClr val="FF0000"/>
              </a:solidFill>
            </a:endParaRP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C-peptide ELISA measurements: </a:t>
            </a:r>
            <a:r>
              <a:rPr lang="en-AU" sz="570" dirty="0"/>
              <a:t>(</a:t>
            </a:r>
            <a:r>
              <a:rPr lang="en-AU" sz="570" dirty="0" smtClean="0"/>
              <a:t>n=26)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Measured in a subset of animals for logistical reasons (plate size).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 C-peptide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25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: </a:t>
            </a:r>
            <a:r>
              <a:rPr lang="en-AU" sz="570" dirty="0"/>
              <a:t>(</a:t>
            </a:r>
            <a:r>
              <a:rPr lang="en-AU" sz="570" dirty="0" smtClean="0"/>
              <a:t>n=1)</a:t>
            </a:r>
          </a:p>
          <a:p>
            <a:r>
              <a:rPr lang="en-AU" sz="570" b="1" dirty="0"/>
              <a:t>Reason: </a:t>
            </a:r>
            <a:r>
              <a:rPr lang="en-AU" sz="570" dirty="0" smtClean="0"/>
              <a:t>One data point outside readable range of the spectrophotometer.</a:t>
            </a:r>
            <a:endParaRPr lang="en-AU" sz="570" dirty="0"/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LV real-time </a:t>
            </a:r>
            <a:r>
              <a:rPr lang="en-AU" sz="570" b="1" dirty="0"/>
              <a:t>qPCR 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</a:t>
            </a:r>
            <a:r>
              <a:rPr lang="en-AU" sz="570" b="1" dirty="0" smtClean="0"/>
              <a:t>LV real-time </a:t>
            </a:r>
            <a:r>
              <a:rPr lang="en-AU" sz="570" b="1" dirty="0"/>
              <a:t>qPCR </a:t>
            </a:r>
            <a:r>
              <a:rPr lang="en-AU" sz="570" b="1" dirty="0" smtClean="0"/>
              <a:t>measurements: </a:t>
            </a:r>
            <a:r>
              <a:rPr lang="en-AU" sz="570" dirty="0"/>
              <a:t>(</a:t>
            </a:r>
            <a:r>
              <a:rPr lang="en-AU" sz="570" dirty="0" smtClean="0"/>
              <a:t>n=32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LV real-time qPCR: </a:t>
            </a:r>
            <a:r>
              <a:rPr lang="en-AU" sz="570" dirty="0" smtClean="0"/>
              <a:t>(n=1)</a:t>
            </a:r>
            <a:endParaRPr lang="en-AU" sz="570" dirty="0"/>
          </a:p>
          <a:p>
            <a:r>
              <a:rPr lang="en-AU" sz="570" b="1" dirty="0"/>
              <a:t>Reason</a:t>
            </a:r>
            <a:r>
              <a:rPr lang="en-AU" sz="570" dirty="0"/>
              <a:t>: </a:t>
            </a:r>
            <a:r>
              <a:rPr lang="en-AU" sz="570" dirty="0" smtClean="0"/>
              <a:t>Housekeeper (18S) </a:t>
            </a:r>
            <a:r>
              <a:rPr lang="en-AU" sz="570" dirty="0"/>
              <a:t>threshold cycle </a:t>
            </a:r>
            <a:r>
              <a:rPr lang="en-AU" sz="570" dirty="0" smtClean="0"/>
              <a:t>2.59 cycles (6.02 SD) above </a:t>
            </a:r>
            <a:r>
              <a:rPr lang="en-AU" sz="570" dirty="0"/>
              <a:t>the mean.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week 26 </a:t>
            </a:r>
            <a:r>
              <a:rPr lang="en-AU" sz="570" b="1" dirty="0"/>
              <a:t>echocardiography measurements:</a:t>
            </a:r>
            <a:r>
              <a:rPr lang="en-AU" sz="570" dirty="0"/>
              <a:t> 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week 26 </a:t>
            </a:r>
            <a:r>
              <a:rPr lang="en-AU" sz="570" b="1" dirty="0"/>
              <a:t>M-mode </a:t>
            </a:r>
            <a:r>
              <a:rPr lang="en-AU" sz="570" b="1" dirty="0" smtClean="0"/>
              <a:t>echocardiography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week 26 </a:t>
            </a:r>
            <a:r>
              <a:rPr lang="en-AU" sz="570" b="1" dirty="0"/>
              <a:t>M-mode </a:t>
            </a:r>
            <a:r>
              <a:rPr lang="en-AU" sz="570" b="1" dirty="0" smtClean="0"/>
              <a:t>echocardiography: </a:t>
            </a:r>
            <a:r>
              <a:rPr lang="en-AU" sz="570" dirty="0"/>
              <a:t>(n=0)</a:t>
            </a:r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week 26 </a:t>
            </a:r>
            <a:r>
              <a:rPr lang="en-AU" sz="570" b="1" dirty="0"/>
              <a:t>Doppler </a:t>
            </a:r>
            <a:r>
              <a:rPr lang="en-AU" sz="570" b="1" dirty="0" smtClean="0"/>
              <a:t>echocardiography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week 26 </a:t>
            </a:r>
            <a:r>
              <a:rPr lang="en-AU" sz="570" b="1" dirty="0"/>
              <a:t>Doppler </a:t>
            </a:r>
            <a:r>
              <a:rPr lang="en-AU" sz="570" b="1" dirty="0" smtClean="0"/>
              <a:t>echocardiography: </a:t>
            </a:r>
            <a:r>
              <a:rPr lang="en-AU" sz="570" dirty="0"/>
              <a:t>(n=0)</a:t>
            </a:r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week 26 </a:t>
            </a:r>
            <a:r>
              <a:rPr lang="en-AU" sz="570" b="1" dirty="0"/>
              <a:t>tissue Doppler </a:t>
            </a:r>
            <a:r>
              <a:rPr lang="en-AU" sz="570" b="1" dirty="0" smtClean="0"/>
              <a:t>echocardiography: </a:t>
            </a:r>
            <a:r>
              <a:rPr lang="en-AU" sz="570" dirty="0"/>
              <a:t>(</a:t>
            </a:r>
            <a:r>
              <a:rPr lang="en-AU" sz="570" dirty="0" smtClean="0"/>
              <a:t>n=32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week 26 </a:t>
            </a:r>
            <a:r>
              <a:rPr lang="en-AU" sz="570" b="1" dirty="0"/>
              <a:t>tissue Doppler </a:t>
            </a:r>
            <a:r>
              <a:rPr lang="en-AU" sz="570" b="1" dirty="0" smtClean="0"/>
              <a:t>echocardiography: </a:t>
            </a:r>
            <a:r>
              <a:rPr lang="en-AU" sz="570" dirty="0"/>
              <a:t>(</a:t>
            </a:r>
            <a:r>
              <a:rPr lang="en-AU" sz="570" dirty="0" smtClean="0"/>
              <a:t>n=1)</a:t>
            </a:r>
          </a:p>
          <a:p>
            <a:r>
              <a:rPr lang="en-AU" sz="570" dirty="0" smtClean="0"/>
              <a:t>Reason: Heart rate too fast (497bpm) – no E/A separation.</a:t>
            </a:r>
          </a:p>
          <a:p>
            <a:r>
              <a:rPr lang="en-AU" sz="570" b="1" dirty="0" smtClean="0"/>
              <a:t>Included in baseline and week 18 echocardiography measurements:</a:t>
            </a:r>
            <a:r>
              <a:rPr lang="en-AU" sz="570" dirty="0" smtClean="0"/>
              <a:t> (n=8)</a:t>
            </a:r>
          </a:p>
          <a:p>
            <a:r>
              <a:rPr lang="en-AU" sz="570" b="1" dirty="0" smtClean="0"/>
              <a:t>Reason: </a:t>
            </a:r>
            <a:r>
              <a:rPr lang="en-AU" sz="570" dirty="0" smtClean="0"/>
              <a:t>Subset of animals measured due to practical reasons.</a:t>
            </a:r>
          </a:p>
          <a:p>
            <a:r>
              <a:rPr lang="en-AU" sz="570" b="1" dirty="0" smtClean="0"/>
              <a:t>Data reported for baseline and week 18 M-mode echocardiography: </a:t>
            </a:r>
            <a:r>
              <a:rPr lang="en-AU" sz="570" dirty="0" smtClean="0"/>
              <a:t>(n=8)</a:t>
            </a:r>
          </a:p>
          <a:p>
            <a:r>
              <a:rPr lang="en-AU" sz="570" b="1" dirty="0" smtClean="0"/>
              <a:t>Data not reported for baseline and week 18 M-mode echocardiography: </a:t>
            </a:r>
            <a:r>
              <a:rPr lang="en-AU" sz="570" dirty="0" smtClean="0"/>
              <a:t>(n=0)</a:t>
            </a:r>
          </a:p>
          <a:p>
            <a:r>
              <a:rPr lang="en-AU" sz="570" b="1" dirty="0" smtClean="0"/>
              <a:t>Data reported for baseline and week 18 Doppler echocardiography: </a:t>
            </a:r>
            <a:r>
              <a:rPr lang="en-AU" sz="570" dirty="0" smtClean="0"/>
              <a:t>(n=8)</a:t>
            </a:r>
          </a:p>
          <a:p>
            <a:r>
              <a:rPr lang="en-AU" sz="570" b="1" dirty="0" smtClean="0"/>
              <a:t>Data not reported for baseline and week 18 Doppler echocardiography: </a:t>
            </a:r>
            <a:r>
              <a:rPr lang="en-AU" sz="570" dirty="0" smtClean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western blotting measurements:</a:t>
            </a:r>
            <a:r>
              <a:rPr lang="en-AU" sz="570" dirty="0"/>
              <a:t> (</a:t>
            </a:r>
            <a:r>
              <a:rPr lang="en-AU" sz="570" dirty="0" smtClean="0"/>
              <a:t>n=22)</a:t>
            </a:r>
            <a:endParaRPr lang="en-AU" sz="570" dirty="0"/>
          </a:p>
          <a:p>
            <a:r>
              <a:rPr lang="en-AU" sz="570" b="1" dirty="0"/>
              <a:t>Reason:</a:t>
            </a:r>
            <a:r>
              <a:rPr lang="en-AU" sz="570" dirty="0"/>
              <a:t> Subset of animals measured due to sample availability.</a:t>
            </a:r>
          </a:p>
          <a:p>
            <a:r>
              <a:rPr lang="en-AU" sz="570" b="1" dirty="0"/>
              <a:t>Data reported for JNK western blotting measurements: </a:t>
            </a:r>
            <a:r>
              <a:rPr lang="en-AU" sz="570" dirty="0"/>
              <a:t>(</a:t>
            </a:r>
            <a:r>
              <a:rPr lang="en-AU" sz="570" dirty="0" smtClean="0"/>
              <a:t>n=22)</a:t>
            </a:r>
            <a:endParaRPr lang="en-AU" sz="570" dirty="0"/>
          </a:p>
          <a:p>
            <a:r>
              <a:rPr lang="en-AU" sz="570" b="1" dirty="0"/>
              <a:t>Data not reported for JNK western blotting measurements: </a:t>
            </a:r>
            <a:r>
              <a:rPr lang="en-AU" sz="570" dirty="0"/>
              <a:t>(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mesangial expansion measurements: </a:t>
            </a:r>
            <a:r>
              <a:rPr lang="en-AU" sz="570" dirty="0"/>
              <a:t>(n=33)</a:t>
            </a:r>
          </a:p>
          <a:p>
            <a:r>
              <a:rPr lang="en-AU" sz="570" b="1" dirty="0"/>
              <a:t>Data reported for mesangial expansion measurements:</a:t>
            </a:r>
            <a:r>
              <a:rPr lang="en-AU" sz="570" dirty="0"/>
              <a:t> (n=31)</a:t>
            </a:r>
          </a:p>
          <a:p>
            <a:r>
              <a:rPr lang="en-AU" sz="570" b="1" dirty="0"/>
              <a:t>Data not reported for mesangial expansion:</a:t>
            </a:r>
            <a:r>
              <a:rPr lang="en-AU" sz="570" dirty="0"/>
              <a:t> (n=2)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P</a:t>
            </a:r>
            <a:r>
              <a:rPr lang="en-AU" sz="570" dirty="0" smtClean="0"/>
              <a:t>roblem </a:t>
            </a:r>
            <a:r>
              <a:rPr lang="en-AU" sz="570" dirty="0"/>
              <a:t>with tissue processing prior to staining.</a:t>
            </a:r>
          </a:p>
          <a:p>
            <a:r>
              <a:rPr lang="en-AU" sz="570" b="1" dirty="0"/>
              <a:t>Included in kidney real-time qPCR measurements: </a:t>
            </a:r>
            <a:r>
              <a:rPr lang="en-AU" sz="570" dirty="0"/>
              <a:t>(n=33)</a:t>
            </a:r>
          </a:p>
          <a:p>
            <a:r>
              <a:rPr lang="en-AU" sz="570" b="1" dirty="0"/>
              <a:t>Data reported for kidney real-time qPCR measurements:</a:t>
            </a:r>
            <a:r>
              <a:rPr lang="en-AU" sz="570" dirty="0"/>
              <a:t> (n=33)</a:t>
            </a:r>
          </a:p>
          <a:p>
            <a:r>
              <a:rPr lang="en-AU" sz="570" b="1" dirty="0"/>
              <a:t>Data not reported for kidney real-time qPCR:</a:t>
            </a:r>
            <a:r>
              <a:rPr lang="en-AU" sz="570" dirty="0"/>
              <a:t> (n=0)</a:t>
            </a:r>
          </a:p>
          <a:p>
            <a:r>
              <a:rPr lang="en-AU" sz="570" b="1" dirty="0"/>
              <a:t>Included in albumin ELISA measurements:</a:t>
            </a:r>
            <a:r>
              <a:rPr lang="en-AU" sz="570" dirty="0"/>
              <a:t> (n=13) 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Subset of animals measured due to practical reasons.</a:t>
            </a:r>
          </a:p>
          <a:p>
            <a:r>
              <a:rPr lang="en-AU" sz="570" b="1" dirty="0"/>
              <a:t>Data reported for  C-peptide measurements: </a:t>
            </a:r>
            <a:r>
              <a:rPr lang="en-AU" sz="570" dirty="0"/>
              <a:t>(n=13)</a:t>
            </a:r>
          </a:p>
          <a:p>
            <a:r>
              <a:rPr lang="en-AU" sz="570" b="1" dirty="0"/>
              <a:t>Data not reported:</a:t>
            </a:r>
            <a:r>
              <a:rPr lang="en-AU" sz="570" dirty="0"/>
              <a:t> (n=0</a:t>
            </a:r>
            <a:r>
              <a:rPr lang="en-AU" sz="570" dirty="0" smtClean="0"/>
              <a:t>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40247" y="2206045"/>
            <a:ext cx="2880000" cy="180049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Animals at endpoint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1800161" y="2030106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3615494" y="2200174"/>
            <a:ext cx="2880000" cy="180049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Animals at endpoint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</p:txBody>
      </p:sp>
      <p:cxnSp>
        <p:nvCxnSpPr>
          <p:cNvPr id="49" name="Straight Connector 48"/>
          <p:cNvCxnSpPr/>
          <p:nvPr/>
        </p:nvCxnSpPr>
        <p:spPr>
          <a:xfrm>
            <a:off x="5075408" y="2032188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1800161" y="2380223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5081182" y="2380223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>
            <a:off x="340247" y="285569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6928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1</a:t>
            </a:r>
            <a:endParaRPr lang="en-AU" b="1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346791" y="3120292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611704" y="2856627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3618243" y="3121228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53334" y="3373669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3624787" y="3368992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350214" y="3800950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3621667" y="3801886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339928" y="4245061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3616992" y="4245994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3629144" y="4852790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37124" y="4853724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349278" y="5376371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3615123" y="5371696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3627276" y="5810198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346471" y="581113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3633819" y="6153332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347407" y="6154265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353951" y="6855987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3619795" y="6856921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3619793" y="7367265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338995" y="736856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3626336" y="7711219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339924" y="7718125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3633811" y="8324559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341791" y="833146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338053" y="806664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3615113" y="8055998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16266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0247" y="568397"/>
            <a:ext cx="2880000" cy="2285241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 smtClean="0"/>
              <a:t>Included </a:t>
            </a:r>
            <a:r>
              <a:rPr lang="en-AU" sz="570" b="1" dirty="0"/>
              <a:t>in </a:t>
            </a:r>
            <a:r>
              <a:rPr lang="en-AU" sz="570" b="1" dirty="0" smtClean="0"/>
              <a:t>liver </a:t>
            </a:r>
            <a:r>
              <a:rPr lang="en-AU" sz="570" b="1" dirty="0"/>
              <a:t>real-time qPCR measurements: </a:t>
            </a:r>
            <a:r>
              <a:rPr lang="en-AU" sz="570" dirty="0"/>
              <a:t>(</a:t>
            </a:r>
            <a:r>
              <a:rPr lang="en-AU" sz="570" dirty="0" smtClean="0"/>
              <a:t>n=9)</a:t>
            </a:r>
          </a:p>
          <a:p>
            <a:r>
              <a:rPr lang="en-AU" sz="570" b="1" dirty="0" smtClean="0"/>
              <a:t>Reason:</a:t>
            </a:r>
            <a:r>
              <a:rPr lang="en-AU" sz="570" dirty="0" smtClean="0"/>
              <a:t> Only a subset </a:t>
            </a:r>
            <a:r>
              <a:rPr lang="en-AU" sz="570" dirty="0"/>
              <a:t>of animals </a:t>
            </a:r>
            <a:r>
              <a:rPr lang="en-AU" sz="570" dirty="0" smtClean="0"/>
              <a:t>measured</a:t>
            </a:r>
            <a:endParaRPr lang="en-AU" sz="570" dirty="0"/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liver </a:t>
            </a:r>
            <a:r>
              <a:rPr lang="en-AU" sz="570" b="1" dirty="0"/>
              <a:t>real-time qPCR measurements: </a:t>
            </a:r>
            <a:r>
              <a:rPr lang="en-AU" sz="570" dirty="0" smtClean="0"/>
              <a:t>(</a:t>
            </a:r>
            <a:r>
              <a:rPr lang="en-AU" sz="570" i="1" dirty="0" smtClean="0"/>
              <a:t>Cd36</a:t>
            </a:r>
            <a:r>
              <a:rPr lang="en-AU" sz="570" dirty="0" smtClean="0"/>
              <a:t>, n=9; </a:t>
            </a:r>
            <a:r>
              <a:rPr lang="en-AU" sz="570" i="1" dirty="0" smtClean="0"/>
              <a:t>CCL2</a:t>
            </a:r>
            <a:r>
              <a:rPr lang="en-AU" sz="570" dirty="0" smtClean="0"/>
              <a:t>, n=9, </a:t>
            </a:r>
            <a:r>
              <a:rPr lang="en-AU" sz="570" i="1" dirty="0" err="1" smtClean="0"/>
              <a:t>Postn</a:t>
            </a:r>
            <a:r>
              <a:rPr lang="en-AU" sz="570" dirty="0" smtClean="0"/>
              <a:t>, n=8; </a:t>
            </a:r>
            <a:r>
              <a:rPr lang="en-AU" sz="570" i="1" dirty="0" smtClean="0"/>
              <a:t>ProCol3</a:t>
            </a:r>
            <a:r>
              <a:rPr lang="en-AU" sz="570" dirty="0" smtClean="0"/>
              <a:t>, n=9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 liver </a:t>
            </a:r>
            <a:r>
              <a:rPr lang="en-AU" sz="570" b="1" dirty="0"/>
              <a:t>LV real-time qPCR: </a:t>
            </a:r>
            <a:r>
              <a:rPr lang="en-AU" sz="570" dirty="0" smtClean="0"/>
              <a:t>(</a:t>
            </a:r>
            <a:r>
              <a:rPr lang="en-AU" sz="570" i="1" dirty="0"/>
              <a:t>Cd36</a:t>
            </a:r>
            <a:r>
              <a:rPr lang="en-AU" sz="570" dirty="0"/>
              <a:t>, </a:t>
            </a:r>
            <a:r>
              <a:rPr lang="en-AU" sz="570" dirty="0" smtClean="0"/>
              <a:t>n=0; </a:t>
            </a:r>
            <a:r>
              <a:rPr lang="en-AU" sz="570" i="1" dirty="0"/>
              <a:t>CCL2</a:t>
            </a:r>
            <a:r>
              <a:rPr lang="en-AU" sz="570" dirty="0"/>
              <a:t>, </a:t>
            </a:r>
            <a:r>
              <a:rPr lang="en-AU" sz="570" dirty="0" smtClean="0"/>
              <a:t>n=0, </a:t>
            </a:r>
            <a:r>
              <a:rPr lang="en-AU" sz="570" i="1" dirty="0" err="1"/>
              <a:t>Postn</a:t>
            </a:r>
            <a:r>
              <a:rPr lang="en-AU" sz="570" dirty="0"/>
              <a:t>, </a:t>
            </a:r>
            <a:r>
              <a:rPr lang="en-AU" sz="570" dirty="0" smtClean="0"/>
              <a:t>n=1; </a:t>
            </a:r>
            <a:r>
              <a:rPr lang="en-AU" sz="570" i="1" dirty="0"/>
              <a:t>ProCol3</a:t>
            </a:r>
            <a:r>
              <a:rPr lang="en-AU" sz="570" dirty="0"/>
              <a:t>, </a:t>
            </a:r>
            <a:r>
              <a:rPr lang="en-AU" sz="570" dirty="0" smtClean="0"/>
              <a:t>n=0)</a:t>
            </a:r>
            <a:endParaRPr lang="en-AU" sz="570" dirty="0"/>
          </a:p>
          <a:p>
            <a:r>
              <a:rPr lang="en-AU" sz="570" b="1" dirty="0"/>
              <a:t>Reason: </a:t>
            </a:r>
            <a:r>
              <a:rPr lang="en-AU" sz="570" dirty="0"/>
              <a:t>Extreme </a:t>
            </a:r>
            <a:r>
              <a:rPr lang="en-AU" sz="570" dirty="0" smtClean="0"/>
              <a:t>outliers </a:t>
            </a:r>
            <a:r>
              <a:rPr lang="en-AU" sz="570" dirty="0"/>
              <a:t>excluded as value greater than the upper quartile plus 3*interquartile range.</a:t>
            </a:r>
            <a:endParaRPr lang="en-AU" sz="570" dirty="0">
              <a:solidFill>
                <a:srgbClr val="FF0000"/>
              </a:solidFill>
            </a:endParaRPr>
          </a:p>
          <a:p>
            <a:r>
              <a:rPr lang="en-AU" sz="570" b="1" dirty="0" smtClean="0"/>
              <a:t>Included in serum cholesterol measurements: </a:t>
            </a:r>
            <a:r>
              <a:rPr lang="en-AU" sz="570" dirty="0" smtClean="0"/>
              <a:t>(n=14)</a:t>
            </a:r>
            <a:endParaRPr lang="en-AU" sz="570" dirty="0"/>
          </a:p>
          <a:p>
            <a:r>
              <a:rPr lang="en-AU" sz="570" b="1" dirty="0"/>
              <a:t>Data reported </a:t>
            </a:r>
            <a:r>
              <a:rPr lang="en-AU" sz="570" b="1" dirty="0" smtClean="0"/>
              <a:t>for serum </a:t>
            </a:r>
            <a:r>
              <a:rPr lang="en-AU" sz="570" b="1" dirty="0"/>
              <a:t>cholesterol measurements: </a:t>
            </a:r>
            <a:r>
              <a:rPr lang="en-AU" sz="570" dirty="0"/>
              <a:t>(</a:t>
            </a:r>
            <a:r>
              <a:rPr lang="en-AU" sz="570" dirty="0" smtClean="0"/>
              <a:t>n=14)</a:t>
            </a:r>
            <a:endParaRPr lang="en-AU" sz="570" dirty="0"/>
          </a:p>
          <a:p>
            <a:r>
              <a:rPr lang="en-AU" sz="570" b="1" dirty="0"/>
              <a:t>Data not </a:t>
            </a:r>
            <a:r>
              <a:rPr lang="en-AU" sz="570" b="1" dirty="0" smtClean="0"/>
              <a:t>reported for </a:t>
            </a:r>
            <a:r>
              <a:rPr lang="en-AU" sz="570" b="1" dirty="0"/>
              <a:t>serum cholesterol measurements: </a:t>
            </a:r>
            <a:r>
              <a:rPr lang="en-AU" sz="570" dirty="0"/>
              <a:t>(</a:t>
            </a:r>
            <a:r>
              <a:rPr lang="en-AU" sz="570" dirty="0" smtClean="0"/>
              <a:t>n=0)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serum </a:t>
            </a:r>
            <a:r>
              <a:rPr lang="en-AU" sz="570" b="1" dirty="0" smtClean="0"/>
              <a:t>ALT and AST </a:t>
            </a:r>
            <a:r>
              <a:rPr lang="en-AU" sz="570" b="1" dirty="0"/>
              <a:t>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 for </a:t>
            </a:r>
            <a:r>
              <a:rPr lang="en-AU" sz="570" b="1" dirty="0" smtClean="0"/>
              <a:t>ALT and AST </a:t>
            </a:r>
            <a:r>
              <a:rPr lang="en-AU" sz="570" b="1" dirty="0"/>
              <a:t>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ALT and AST </a:t>
            </a:r>
            <a:r>
              <a:rPr lang="en-AU" sz="570" b="1" dirty="0"/>
              <a:t>measurements: </a:t>
            </a:r>
            <a:r>
              <a:rPr lang="en-AU" sz="570" dirty="0"/>
              <a:t>(n=0)</a:t>
            </a:r>
          </a:p>
          <a:p>
            <a:endParaRPr lang="en-AU" sz="570" dirty="0" smtClean="0"/>
          </a:p>
          <a:p>
            <a:endParaRPr lang="en-AU" sz="570" dirty="0" smtClean="0"/>
          </a:p>
          <a:p>
            <a:r>
              <a:rPr lang="en-AU" sz="570" b="1" dirty="0"/>
              <a:t>Included in NASH scoring: </a:t>
            </a:r>
            <a:r>
              <a:rPr lang="en-AU" sz="570" dirty="0"/>
              <a:t>(</a:t>
            </a:r>
            <a:r>
              <a:rPr lang="en-AU" sz="570" dirty="0" smtClean="0"/>
              <a:t>n=12)</a:t>
            </a:r>
            <a:endParaRPr lang="en-AU" sz="570" dirty="0"/>
          </a:p>
          <a:p>
            <a:r>
              <a:rPr lang="en-AU" sz="570" b="1" dirty="0"/>
              <a:t>Reason:</a:t>
            </a:r>
            <a:r>
              <a:rPr lang="en-AU" sz="570" dirty="0"/>
              <a:t> Only a subset of animals measured</a:t>
            </a:r>
          </a:p>
          <a:p>
            <a:r>
              <a:rPr lang="en-AU" sz="570" b="1" dirty="0"/>
              <a:t>Data reported for NASH scoring: </a:t>
            </a:r>
            <a:r>
              <a:rPr lang="en-AU" sz="570" dirty="0"/>
              <a:t>(</a:t>
            </a:r>
            <a:r>
              <a:rPr lang="en-AU" sz="570" dirty="0" smtClean="0"/>
              <a:t>n=12)</a:t>
            </a:r>
            <a:endParaRPr lang="en-AU" sz="570" dirty="0"/>
          </a:p>
          <a:p>
            <a:r>
              <a:rPr lang="en-AU" sz="570" b="1" dirty="0"/>
              <a:t>Data not reported for NASH scoring: </a:t>
            </a:r>
            <a:r>
              <a:rPr lang="en-AU" sz="570" dirty="0"/>
              <a:t>(n=0</a:t>
            </a:r>
            <a:r>
              <a:rPr lang="en-AU" sz="570" dirty="0" smtClean="0"/>
              <a:t>)</a:t>
            </a:r>
          </a:p>
          <a:p>
            <a:r>
              <a:rPr lang="en-AU" sz="570" b="1" dirty="0"/>
              <a:t>Included in </a:t>
            </a:r>
            <a:r>
              <a:rPr lang="en-AU" sz="570" b="1" dirty="0" err="1" smtClean="0"/>
              <a:t>picrosirius</a:t>
            </a:r>
            <a:r>
              <a:rPr lang="en-AU" sz="570" b="1" dirty="0" smtClean="0"/>
              <a:t> red staining and H&amp;E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 for </a:t>
            </a:r>
            <a:r>
              <a:rPr lang="en-AU" sz="570" b="1" dirty="0" err="1"/>
              <a:t>picrosirius</a:t>
            </a:r>
            <a:r>
              <a:rPr lang="en-AU" sz="570" b="1" dirty="0"/>
              <a:t> red staining</a:t>
            </a:r>
            <a:r>
              <a:rPr lang="en-AU" sz="570" b="1" dirty="0" smtClean="0"/>
              <a:t> </a:t>
            </a:r>
            <a:r>
              <a:rPr lang="en-AU" sz="570" b="1" dirty="0"/>
              <a:t>and H&amp;E measurements</a:t>
            </a:r>
            <a:r>
              <a:rPr lang="en-AU" sz="570" b="1" dirty="0" smtClean="0"/>
              <a:t>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not reported: </a:t>
            </a:r>
            <a:r>
              <a:rPr lang="en-AU" sz="570" dirty="0"/>
              <a:t>(n=0)</a:t>
            </a:r>
            <a:endParaRPr lang="en-AU" sz="570" dirty="0">
              <a:solidFill>
                <a:srgbClr val="FF0000"/>
              </a:solidFill>
            </a:endParaRPr>
          </a:p>
          <a:p>
            <a:endParaRPr lang="en-AU" sz="570" dirty="0" smtClean="0"/>
          </a:p>
          <a:p>
            <a:endParaRPr lang="en-AU" sz="570" dirty="0"/>
          </a:p>
          <a:p>
            <a:endParaRPr lang="en-AU" sz="570" dirty="0"/>
          </a:p>
        </p:txBody>
      </p:sp>
      <p:sp>
        <p:nvSpPr>
          <p:cNvPr id="5" name="TextBox 4"/>
          <p:cNvSpPr txBox="1"/>
          <p:nvPr/>
        </p:nvSpPr>
        <p:spPr>
          <a:xfrm>
            <a:off x="3624456" y="568397"/>
            <a:ext cx="2871037" cy="219752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 smtClean="0"/>
              <a:t>Included </a:t>
            </a:r>
            <a:r>
              <a:rPr lang="en-AU" sz="570" b="1" dirty="0"/>
              <a:t>in liver real-time qPCR measurements: </a:t>
            </a:r>
            <a:r>
              <a:rPr lang="en-AU" sz="570" dirty="0"/>
              <a:t>(</a:t>
            </a:r>
            <a:r>
              <a:rPr lang="en-AU" sz="570" dirty="0" smtClean="0"/>
              <a:t>n=22)</a:t>
            </a:r>
            <a:endParaRPr lang="en-AU" sz="570" dirty="0"/>
          </a:p>
          <a:p>
            <a:r>
              <a:rPr lang="en-AU" sz="570" b="1" dirty="0" smtClean="0"/>
              <a:t>Reason:</a:t>
            </a:r>
            <a:r>
              <a:rPr lang="en-AU" sz="570" dirty="0" smtClean="0"/>
              <a:t> Only a subset </a:t>
            </a:r>
            <a:r>
              <a:rPr lang="en-AU" sz="570" dirty="0"/>
              <a:t>of animals measured</a:t>
            </a:r>
          </a:p>
          <a:p>
            <a:r>
              <a:rPr lang="en-AU" sz="570" b="1" dirty="0"/>
              <a:t>Data reported for liver real-time qPCR measurements: </a:t>
            </a:r>
            <a:r>
              <a:rPr lang="en-AU" sz="570" dirty="0"/>
              <a:t>(</a:t>
            </a:r>
            <a:r>
              <a:rPr lang="en-AU" sz="570" i="1" dirty="0"/>
              <a:t>Cd36</a:t>
            </a:r>
            <a:r>
              <a:rPr lang="en-AU" sz="570" dirty="0"/>
              <a:t>, </a:t>
            </a:r>
            <a:r>
              <a:rPr lang="en-AU" sz="570" dirty="0" smtClean="0"/>
              <a:t>n=22; </a:t>
            </a:r>
            <a:r>
              <a:rPr lang="en-AU" sz="570" i="1" dirty="0"/>
              <a:t>CCL2</a:t>
            </a:r>
            <a:r>
              <a:rPr lang="en-AU" sz="570" dirty="0"/>
              <a:t>, </a:t>
            </a:r>
            <a:r>
              <a:rPr lang="en-AU" sz="570" dirty="0" smtClean="0"/>
              <a:t>n=21, </a:t>
            </a:r>
            <a:r>
              <a:rPr lang="en-AU" sz="570" i="1" dirty="0" err="1"/>
              <a:t>Postn</a:t>
            </a:r>
            <a:r>
              <a:rPr lang="en-AU" sz="570" dirty="0"/>
              <a:t>, </a:t>
            </a:r>
            <a:r>
              <a:rPr lang="en-AU" sz="570" dirty="0" smtClean="0"/>
              <a:t>n=20; </a:t>
            </a:r>
            <a:r>
              <a:rPr lang="en-AU" sz="570" i="1" dirty="0"/>
              <a:t>ProCol3</a:t>
            </a:r>
            <a:r>
              <a:rPr lang="en-AU" sz="570" dirty="0"/>
              <a:t>, </a:t>
            </a:r>
            <a:r>
              <a:rPr lang="en-AU" sz="570" dirty="0" smtClean="0"/>
              <a:t>n=19</a:t>
            </a:r>
            <a:r>
              <a:rPr lang="en-AU" sz="570" dirty="0"/>
              <a:t>)</a:t>
            </a:r>
          </a:p>
          <a:p>
            <a:r>
              <a:rPr lang="en-AU" sz="570" b="1" dirty="0"/>
              <a:t>Data not reported </a:t>
            </a:r>
            <a:r>
              <a:rPr lang="en-AU" sz="570" b="1" dirty="0" smtClean="0"/>
              <a:t>liver </a:t>
            </a:r>
            <a:r>
              <a:rPr lang="en-AU" sz="570" b="1" dirty="0"/>
              <a:t>LV real-time qPCR: </a:t>
            </a:r>
            <a:r>
              <a:rPr lang="en-AU" sz="570" dirty="0"/>
              <a:t>(</a:t>
            </a:r>
            <a:r>
              <a:rPr lang="en-AU" sz="570" i="1" dirty="0"/>
              <a:t>Cd36</a:t>
            </a:r>
            <a:r>
              <a:rPr lang="en-AU" sz="570" dirty="0"/>
              <a:t>, </a:t>
            </a:r>
            <a:r>
              <a:rPr lang="en-AU" sz="570" dirty="0" smtClean="0"/>
              <a:t>n=0; </a:t>
            </a:r>
            <a:r>
              <a:rPr lang="en-AU" sz="570" i="1" dirty="0"/>
              <a:t>CCL2</a:t>
            </a:r>
            <a:r>
              <a:rPr lang="en-AU" sz="570" dirty="0"/>
              <a:t>, </a:t>
            </a:r>
            <a:r>
              <a:rPr lang="en-AU" sz="570" dirty="0" smtClean="0"/>
              <a:t>n=1, </a:t>
            </a:r>
            <a:r>
              <a:rPr lang="en-AU" sz="570" i="1" dirty="0" err="1"/>
              <a:t>Postn</a:t>
            </a:r>
            <a:r>
              <a:rPr lang="en-AU" sz="570" dirty="0"/>
              <a:t>, </a:t>
            </a:r>
            <a:r>
              <a:rPr lang="en-AU" sz="570" dirty="0" smtClean="0"/>
              <a:t>n=2; </a:t>
            </a:r>
            <a:r>
              <a:rPr lang="en-AU" sz="570" i="1" dirty="0"/>
              <a:t>ProCol3</a:t>
            </a:r>
            <a:r>
              <a:rPr lang="en-AU" sz="570" dirty="0"/>
              <a:t>, </a:t>
            </a:r>
            <a:r>
              <a:rPr lang="en-AU" sz="570" dirty="0" smtClean="0"/>
              <a:t>n=2)</a:t>
            </a:r>
            <a:endParaRPr lang="en-AU" sz="570" dirty="0"/>
          </a:p>
          <a:p>
            <a:r>
              <a:rPr lang="en-AU" sz="570" b="1" dirty="0"/>
              <a:t>Reason: </a:t>
            </a:r>
            <a:r>
              <a:rPr lang="en-AU" sz="570" dirty="0"/>
              <a:t>Extreme </a:t>
            </a:r>
            <a:r>
              <a:rPr lang="en-AU" sz="570" dirty="0" smtClean="0"/>
              <a:t>outliers </a:t>
            </a:r>
            <a:r>
              <a:rPr lang="en-AU" sz="570" dirty="0"/>
              <a:t>excluded as value greater than the upper quartile plus 3*interquartile range</a:t>
            </a:r>
            <a:r>
              <a:rPr lang="en-AU" sz="570" dirty="0" smtClean="0"/>
              <a:t>.</a:t>
            </a:r>
          </a:p>
          <a:p>
            <a:r>
              <a:rPr lang="en-AU" sz="570" b="1" dirty="0" smtClean="0"/>
              <a:t>Included </a:t>
            </a:r>
            <a:r>
              <a:rPr lang="en-AU" sz="570" b="1" dirty="0"/>
              <a:t>in serum cholesterol 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reported for serum cholesterol 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not reported for serum cholesterol measurements: </a:t>
            </a:r>
            <a:r>
              <a:rPr lang="en-AU" sz="570" dirty="0"/>
              <a:t>(n=0</a:t>
            </a:r>
            <a:r>
              <a:rPr lang="en-AU" sz="570" dirty="0" smtClean="0"/>
              <a:t>)</a:t>
            </a:r>
          </a:p>
          <a:p>
            <a:r>
              <a:rPr lang="en-AU" sz="570" b="1" dirty="0"/>
              <a:t>Included in serum ALT and AST measurements: </a:t>
            </a:r>
            <a:r>
              <a:rPr lang="en-AU" sz="570" dirty="0"/>
              <a:t>(</a:t>
            </a:r>
            <a:r>
              <a:rPr lang="en-AU" sz="570" dirty="0" smtClean="0"/>
              <a:t>n=33)</a:t>
            </a:r>
            <a:endParaRPr lang="en-AU" sz="570" dirty="0"/>
          </a:p>
          <a:p>
            <a:r>
              <a:rPr lang="en-AU" sz="570" b="1" dirty="0"/>
              <a:t>Data reported for ALT and AST measurements: </a:t>
            </a:r>
            <a:r>
              <a:rPr lang="en-AU" sz="570" dirty="0"/>
              <a:t>(</a:t>
            </a:r>
            <a:r>
              <a:rPr lang="en-AU" sz="570" dirty="0" smtClean="0"/>
              <a:t>n=31)</a:t>
            </a:r>
            <a:endParaRPr lang="en-AU" sz="570" dirty="0"/>
          </a:p>
          <a:p>
            <a:r>
              <a:rPr lang="en-AU" sz="570" b="1" dirty="0"/>
              <a:t>Data not reported for ALT and AST measurements: </a:t>
            </a:r>
            <a:r>
              <a:rPr lang="en-AU" sz="570" dirty="0"/>
              <a:t>(</a:t>
            </a:r>
            <a:r>
              <a:rPr lang="en-AU" sz="570" dirty="0" smtClean="0"/>
              <a:t>n=2)</a:t>
            </a:r>
            <a:endParaRPr lang="en-AU" sz="570" dirty="0"/>
          </a:p>
          <a:p>
            <a:r>
              <a:rPr lang="en-AU" sz="570" b="1" dirty="0"/>
              <a:t>Reason: </a:t>
            </a:r>
            <a:r>
              <a:rPr lang="en-AU" sz="570" dirty="0"/>
              <a:t>Extreme </a:t>
            </a:r>
            <a:r>
              <a:rPr lang="en-AU" sz="570" dirty="0" smtClean="0"/>
              <a:t>outlier </a:t>
            </a:r>
            <a:r>
              <a:rPr lang="en-AU" sz="570" dirty="0"/>
              <a:t>excluded as value greater than the upper quartile plus 3*interquartile range</a:t>
            </a:r>
            <a:r>
              <a:rPr lang="en-AU" sz="570" dirty="0" smtClean="0"/>
              <a:t>.</a:t>
            </a:r>
          </a:p>
          <a:p>
            <a:r>
              <a:rPr lang="en-AU" sz="570" b="1" dirty="0"/>
              <a:t>Included in </a:t>
            </a:r>
            <a:r>
              <a:rPr lang="en-AU" sz="570" b="1" dirty="0" smtClean="0"/>
              <a:t>NASH scoring: </a:t>
            </a:r>
            <a:r>
              <a:rPr lang="en-AU" sz="570" dirty="0"/>
              <a:t>(</a:t>
            </a:r>
            <a:r>
              <a:rPr lang="en-AU" sz="570" dirty="0" smtClean="0"/>
              <a:t>n=29)</a:t>
            </a:r>
          </a:p>
          <a:p>
            <a:r>
              <a:rPr lang="en-AU" sz="570" b="1" dirty="0"/>
              <a:t>Reason:</a:t>
            </a:r>
            <a:r>
              <a:rPr lang="en-AU" sz="570" dirty="0"/>
              <a:t> Only a subset of animals measured</a:t>
            </a:r>
          </a:p>
          <a:p>
            <a:r>
              <a:rPr lang="en-AU" sz="570" b="1" dirty="0" smtClean="0"/>
              <a:t>Data </a:t>
            </a:r>
            <a:r>
              <a:rPr lang="en-AU" sz="570" b="1" dirty="0"/>
              <a:t>reported for </a:t>
            </a:r>
            <a:r>
              <a:rPr lang="en-AU" sz="570" b="1" dirty="0" smtClean="0"/>
              <a:t>NASH scoring: </a:t>
            </a:r>
            <a:r>
              <a:rPr lang="en-AU" sz="570" dirty="0"/>
              <a:t>(</a:t>
            </a:r>
            <a:r>
              <a:rPr lang="en-AU" sz="570" dirty="0" smtClean="0"/>
              <a:t>n=29)</a:t>
            </a:r>
            <a:endParaRPr lang="en-AU" sz="570" dirty="0"/>
          </a:p>
          <a:p>
            <a:r>
              <a:rPr lang="en-AU" sz="570" b="1" dirty="0"/>
              <a:t>Data not reported for </a:t>
            </a:r>
            <a:r>
              <a:rPr lang="en-AU" sz="570" b="1" dirty="0" smtClean="0"/>
              <a:t>NASH scoring: </a:t>
            </a:r>
            <a:r>
              <a:rPr lang="en-AU" sz="570" dirty="0"/>
              <a:t>(</a:t>
            </a:r>
            <a:r>
              <a:rPr lang="en-AU" sz="570" dirty="0" smtClean="0"/>
              <a:t>n=0)</a:t>
            </a:r>
          </a:p>
          <a:p>
            <a:r>
              <a:rPr lang="en-AU" sz="570" b="1" dirty="0"/>
              <a:t>Included in </a:t>
            </a:r>
            <a:r>
              <a:rPr lang="en-AU" sz="570" b="1" dirty="0" err="1"/>
              <a:t>picrosirius</a:t>
            </a:r>
            <a:r>
              <a:rPr lang="en-AU" sz="570" b="1" dirty="0"/>
              <a:t> red staining and H&amp;E measurements: </a:t>
            </a:r>
            <a:r>
              <a:rPr lang="en-AU" sz="570" dirty="0"/>
              <a:t>(</a:t>
            </a:r>
            <a:r>
              <a:rPr lang="en-AU" sz="570" dirty="0" smtClean="0"/>
              <a:t>n=32)</a:t>
            </a:r>
          </a:p>
          <a:p>
            <a:r>
              <a:rPr lang="en-AU" sz="570" b="1" dirty="0" smtClean="0"/>
              <a:t>Reason: </a:t>
            </a:r>
            <a:r>
              <a:rPr lang="en-AU" sz="570" dirty="0" smtClean="0"/>
              <a:t>One sample lost during tissue processing.</a:t>
            </a:r>
            <a:endParaRPr lang="en-AU" sz="570" dirty="0"/>
          </a:p>
          <a:p>
            <a:r>
              <a:rPr lang="en-AU" sz="570" b="1" dirty="0"/>
              <a:t>Data reported for </a:t>
            </a:r>
            <a:r>
              <a:rPr lang="en-AU" sz="570" b="1" dirty="0" err="1"/>
              <a:t>picrosirius</a:t>
            </a:r>
            <a:r>
              <a:rPr lang="en-AU" sz="570" b="1" dirty="0"/>
              <a:t> red staining and H&amp;E measurements: </a:t>
            </a:r>
            <a:r>
              <a:rPr lang="en-AU" sz="570" dirty="0"/>
              <a:t>(</a:t>
            </a:r>
            <a:r>
              <a:rPr lang="en-AU" sz="570" dirty="0" smtClean="0"/>
              <a:t>n=32)</a:t>
            </a:r>
            <a:endParaRPr lang="en-AU" sz="570" dirty="0"/>
          </a:p>
          <a:p>
            <a:r>
              <a:rPr lang="en-AU" sz="570" b="1" dirty="0"/>
              <a:t>Data not reported: </a:t>
            </a:r>
            <a:r>
              <a:rPr lang="en-AU" sz="570" dirty="0"/>
              <a:t>(n=0)</a:t>
            </a:r>
            <a:endParaRPr lang="en-AU" sz="570" dirty="0">
              <a:solidFill>
                <a:srgbClr val="FF0000"/>
              </a:solidFill>
            </a:endParaRPr>
          </a:p>
          <a:p>
            <a:endParaRPr lang="en-AU" sz="570" dirty="0">
              <a:solidFill>
                <a:srgbClr val="FF0000"/>
              </a:solidFill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340247" y="121739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611704" y="1218327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40247" y="147774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3611704" y="1485027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346597" y="1915893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624404" y="1911225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-966" y="8181"/>
            <a:ext cx="3027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/>
              <a:t>Supplementary Figure </a:t>
            </a:r>
            <a:r>
              <a:rPr lang="en-AU" b="1" dirty="0" smtClean="0"/>
              <a:t>1 cont</a:t>
            </a:r>
            <a:r>
              <a:rPr lang="en-AU" b="1" dirty="0"/>
              <a:t>.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349591" y="2265511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3615447" y="2266821"/>
            <a:ext cx="28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191763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928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2</a:t>
            </a:r>
            <a:endParaRPr lang="en-AU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6217056"/>
              </p:ext>
            </p:extLst>
          </p:nvPr>
        </p:nvGraphicFramePr>
        <p:xfrm>
          <a:off x="471488" y="840263"/>
          <a:ext cx="5915025" cy="2756086"/>
        </p:xfrm>
        <a:graphic>
          <a:graphicData uri="http://schemas.openxmlformats.org/drawingml/2006/table">
            <a:tbl>
              <a:tblPr/>
              <a:tblGrid>
                <a:gridCol w="707607">
                  <a:extLst>
                    <a:ext uri="{9D8B030D-6E8A-4147-A177-3AD203B41FA5}">
                      <a16:colId xmlns:a16="http://schemas.microsoft.com/office/drawing/2014/main" val="3961075271"/>
                    </a:ext>
                  </a:extLst>
                </a:gridCol>
                <a:gridCol w="625642">
                  <a:extLst>
                    <a:ext uri="{9D8B030D-6E8A-4147-A177-3AD203B41FA5}">
                      <a16:colId xmlns:a16="http://schemas.microsoft.com/office/drawing/2014/main" val="1326601249"/>
                    </a:ext>
                  </a:extLst>
                </a:gridCol>
                <a:gridCol w="48126">
                  <a:extLst>
                    <a:ext uri="{9D8B030D-6E8A-4147-A177-3AD203B41FA5}">
                      <a16:colId xmlns:a16="http://schemas.microsoft.com/office/drawing/2014/main" val="389654468"/>
                    </a:ext>
                  </a:extLst>
                </a:gridCol>
                <a:gridCol w="2057400">
                  <a:extLst>
                    <a:ext uri="{9D8B030D-6E8A-4147-A177-3AD203B41FA5}">
                      <a16:colId xmlns:a16="http://schemas.microsoft.com/office/drawing/2014/main" val="2698981444"/>
                    </a:ext>
                  </a:extLst>
                </a:gridCol>
                <a:gridCol w="2476250">
                  <a:extLst>
                    <a:ext uri="{9D8B030D-6E8A-4147-A177-3AD203B41FA5}">
                      <a16:colId xmlns:a16="http://schemas.microsoft.com/office/drawing/2014/main" val="1879926107"/>
                    </a:ext>
                  </a:extLst>
                </a:gridCol>
              </a:tblGrid>
              <a:tr h="145112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e name</a:t>
                      </a:r>
                    </a:p>
                  </a:txBody>
                  <a:tcPr marL="6910" marR="6910" marT="69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imer Conc. (µM)</a:t>
                      </a:r>
                    </a:p>
                  </a:txBody>
                  <a:tcPr marL="6910" marR="6910" marT="69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imer sequences (5'-3')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43312784"/>
                  </a:ext>
                </a:extLst>
              </a:tr>
              <a:tr h="14511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910" marR="6910" marT="69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orward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verse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1146144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s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GTTCACCATGAGGCTGAGAT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GGTTGCCTGGGAAAATC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0671588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l2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GTCCCTGTCATGCTTCTG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TGGACCCATTCCTTCTTG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4794678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36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TTGGTCAAGCCAGC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GTAGGCTCATCCACTAC 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7737201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4a4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CACGGCCATTCCTTCA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AAAAGAAGAGAAAACCCACTATAGAG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3797222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tgf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GACCCCTGCGACCCACA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ACACCGACCCACCGAAGACACAG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7826135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ef1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CTTCGCTACACTGATCGAGAC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TCAAGCTTCTGATTTTTCCTGAA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8541449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ef2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GGCTCCCTGCCTTATAC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GTGGCCCATAGAGAAAAC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2310028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mp9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ACCAAGGGTACAGCCTGTT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GCACGCTGGAATGATCTAAG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174303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h7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TCCTGCTGTTTCCTTACTTGCTA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TACTCCTCTGCTGAGGCTTCC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8173715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rk2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GCCCTGGACGCACAA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AATGGCTAAGGAAGGTAGGAAT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5892805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rk6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AAAACCAAGCGCGTGTC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GAAGCCCTGCCAGCA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1322444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ostn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TCCTGCTGTTTCCTTACTTGCTA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TACTCCTCTGCTGAGGCTTCC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1170769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oCol3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GGAATGGAGCAAGACAGTCT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GCGATATCTATGATGGTAGTCTCA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2724528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rpine1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CACCCTCAGCATGTTCAT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GGTTGCACTAAACATGTCAG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5372032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a4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TGGCTGTCGCTGGTTTC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CATCCGCAACATACTGGAA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6010293"/>
                  </a:ext>
                </a:extLst>
              </a:tr>
              <a:tr h="14511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sp3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TAGGGCCATGCTCTAAGAGTG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GAGGCCCAGTGTACCGTTT</a:t>
                      </a: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976322"/>
                  </a:ext>
                </a:extLst>
              </a:tr>
              <a:tr h="139584"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910" marR="6910" marT="69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84995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54269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6508" y="1435188"/>
            <a:ext cx="1179576" cy="1620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35" y="1435188"/>
            <a:ext cx="1208944" cy="1620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71259" y="1519436"/>
            <a:ext cx="2396136" cy="16200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0790" y="1519436"/>
            <a:ext cx="2396136" cy="162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6928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3</a:t>
            </a:r>
            <a:endParaRPr lang="en-AU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6928" y="995488"/>
            <a:ext cx="29085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Intraperitoneal </a:t>
            </a:r>
            <a:r>
              <a:rPr lang="en-AU" sz="1400" b="1" dirty="0" smtClean="0"/>
              <a:t>insulin </a:t>
            </a:r>
            <a:r>
              <a:rPr lang="en-AU" sz="1400" b="1" dirty="0" smtClean="0"/>
              <a:t>tolerance test</a:t>
            </a:r>
            <a:endParaRPr lang="en-AU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6928" y="1195604"/>
            <a:ext cx="17134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18wks post-diabetes</a:t>
            </a:r>
            <a:endParaRPr lang="en-AU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644011" y="1195604"/>
            <a:ext cx="17134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26wks post-diabetes</a:t>
            </a:r>
            <a:endParaRPr lang="en-AU" sz="1400" b="1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/>
          <a:srcRect l="80261" t="8649" b="72399"/>
          <a:stretch/>
        </p:blipFill>
        <p:spPr>
          <a:xfrm>
            <a:off x="5792161" y="1268715"/>
            <a:ext cx="893081" cy="469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55597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4687" t="16960" r="16198" b="34633"/>
          <a:stretch/>
        </p:blipFill>
        <p:spPr>
          <a:xfrm>
            <a:off x="689765" y="6734854"/>
            <a:ext cx="3484316" cy="134770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6928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Figure 4</a:t>
            </a:r>
            <a:endParaRPr lang="en-AU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15225" t="24124" r="17397" b="34159"/>
          <a:stretch/>
        </p:blipFill>
        <p:spPr>
          <a:xfrm>
            <a:off x="661674" y="8118256"/>
            <a:ext cx="3512407" cy="120101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526712" y="8150748"/>
            <a:ext cx="532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err="1" smtClean="0"/>
              <a:t>Bax</a:t>
            </a:r>
            <a:endParaRPr lang="en-AU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370656" y="6718448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err="1" smtClean="0"/>
              <a:t>bActin</a:t>
            </a:r>
            <a:endParaRPr lang="en-AU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47536" y="7303045"/>
            <a:ext cx="5245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75kda</a:t>
            </a:r>
            <a:endParaRPr lang="en-AU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46948" y="7554056"/>
            <a:ext cx="5341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50kda</a:t>
            </a:r>
            <a:endParaRPr lang="en-AU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54193" y="7767600"/>
            <a:ext cx="5245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37kda</a:t>
            </a:r>
            <a:endParaRPr lang="en-AU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4234116" y="8555001"/>
            <a:ext cx="8418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err="1" smtClean="0"/>
              <a:t>Bax</a:t>
            </a:r>
            <a:r>
              <a:rPr lang="en-AU" sz="1050" b="1" dirty="0" smtClean="0"/>
              <a:t> (20kda)</a:t>
            </a:r>
            <a:endParaRPr lang="en-AU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200645" y="7623518"/>
            <a:ext cx="10005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err="1" smtClean="0"/>
              <a:t>bActin</a:t>
            </a:r>
            <a:r>
              <a:rPr lang="en-AU" sz="1050" b="1" dirty="0" smtClean="0"/>
              <a:t> (45kda)</a:t>
            </a:r>
            <a:endParaRPr lang="en-AU" b="1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1005766" y="7547342"/>
            <a:ext cx="54543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607344" y="7547342"/>
            <a:ext cx="23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137202" y="7333531"/>
            <a:ext cx="35779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ND</a:t>
            </a:r>
            <a:endParaRPr lang="en-AU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359416" y="7333531"/>
            <a:ext cx="4058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T2D</a:t>
            </a:r>
            <a:endParaRPr lang="en-AU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87889" y="8441072"/>
            <a:ext cx="5245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25kda</a:t>
            </a:r>
            <a:endParaRPr lang="en-AU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87889" y="8617535"/>
            <a:ext cx="5245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/>
              <a:t>2</a:t>
            </a:r>
            <a:r>
              <a:rPr lang="en-AU" sz="1050" b="1" dirty="0" smtClean="0"/>
              <a:t>0kda</a:t>
            </a:r>
            <a:endParaRPr lang="en-AU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87889" y="8960090"/>
            <a:ext cx="5245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15kda</a:t>
            </a:r>
            <a:endParaRPr lang="en-AU" b="1" dirty="0"/>
          </a:p>
        </p:txBody>
      </p:sp>
      <p:sp>
        <p:nvSpPr>
          <p:cNvPr id="25" name="Rectangle 24"/>
          <p:cNvSpPr/>
          <p:nvPr/>
        </p:nvSpPr>
        <p:spPr>
          <a:xfrm>
            <a:off x="779789" y="8214725"/>
            <a:ext cx="1657640" cy="9992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6" name="Rectangle 25"/>
          <p:cNvSpPr/>
          <p:nvPr/>
        </p:nvSpPr>
        <p:spPr>
          <a:xfrm>
            <a:off x="793484" y="7059894"/>
            <a:ext cx="1643945" cy="9591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56" name="Straight Connector 55"/>
          <p:cNvCxnSpPr/>
          <p:nvPr/>
        </p:nvCxnSpPr>
        <p:spPr>
          <a:xfrm>
            <a:off x="412499" y="8129686"/>
            <a:ext cx="4140000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 flipH="1">
            <a:off x="4002871" y="7752869"/>
            <a:ext cx="2537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flipH="1">
            <a:off x="4006681" y="8671079"/>
            <a:ext cx="2537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4487773" y="7991298"/>
            <a:ext cx="22204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Membrane cut before Ab incubation</a:t>
            </a:r>
            <a:endParaRPr lang="en-AU" b="1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1021006" y="8556992"/>
            <a:ext cx="54543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1622584" y="8556992"/>
            <a:ext cx="23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1152442" y="8343181"/>
            <a:ext cx="35779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ND</a:t>
            </a:r>
            <a:endParaRPr lang="en-AU" b="1" dirty="0"/>
          </a:p>
        </p:txBody>
      </p:sp>
      <p:sp>
        <p:nvSpPr>
          <p:cNvPr id="97" name="TextBox 96"/>
          <p:cNvSpPr txBox="1"/>
          <p:nvPr/>
        </p:nvSpPr>
        <p:spPr>
          <a:xfrm>
            <a:off x="2374656" y="8343181"/>
            <a:ext cx="4058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b="1" dirty="0" smtClean="0"/>
              <a:t>T2D</a:t>
            </a:r>
            <a:endParaRPr lang="en-AU" b="1" dirty="0"/>
          </a:p>
        </p:txBody>
      </p:sp>
      <p:sp>
        <p:nvSpPr>
          <p:cNvPr id="119" name="TextBox 118"/>
          <p:cNvSpPr txBox="1"/>
          <p:nvPr/>
        </p:nvSpPr>
        <p:spPr>
          <a:xfrm>
            <a:off x="231527" y="9474251"/>
            <a:ext cx="5298182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AU" sz="1600" b="1" dirty="0" smtClean="0"/>
              <a:t>Red boxes depict cropped areas included in main manuscript</a:t>
            </a:r>
            <a:endParaRPr lang="en-AU" sz="1600" b="1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178" y="2611852"/>
            <a:ext cx="3049478" cy="3989142"/>
          </a:xfrm>
          <a:prstGeom prst="rect">
            <a:avLst/>
          </a:prstGeom>
        </p:spPr>
      </p:pic>
      <p:grpSp>
        <p:nvGrpSpPr>
          <p:cNvPr id="20" name="Group 19"/>
          <p:cNvGrpSpPr/>
          <p:nvPr/>
        </p:nvGrpSpPr>
        <p:grpSpPr>
          <a:xfrm>
            <a:off x="412499" y="291383"/>
            <a:ext cx="4420231" cy="2261742"/>
            <a:chOff x="412499" y="4548357"/>
            <a:chExt cx="4420231" cy="2261742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12499" y="4548357"/>
              <a:ext cx="4420231" cy="2261742"/>
            </a:xfrm>
            <a:prstGeom prst="rect">
              <a:avLst/>
            </a:prstGeom>
          </p:spPr>
        </p:pic>
        <p:sp>
          <p:nvSpPr>
            <p:cNvPr id="139" name="Rectangle 138"/>
            <p:cNvSpPr/>
            <p:nvPr/>
          </p:nvSpPr>
          <p:spPr>
            <a:xfrm>
              <a:off x="812392" y="4873825"/>
              <a:ext cx="1689567" cy="46090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40" name="Rectangle 139"/>
            <p:cNvSpPr/>
            <p:nvPr/>
          </p:nvSpPr>
          <p:spPr>
            <a:xfrm>
              <a:off x="812392" y="6013705"/>
              <a:ext cx="1689567" cy="46090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8358353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928" y="0"/>
            <a:ext cx="2553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ry Methods</a:t>
            </a:r>
            <a:endParaRPr lang="en-AU" b="1" dirty="0"/>
          </a:p>
        </p:txBody>
      </p:sp>
      <p:sp>
        <p:nvSpPr>
          <p:cNvPr id="5" name="Rectangle 4"/>
          <p:cNvSpPr/>
          <p:nvPr/>
        </p:nvSpPr>
        <p:spPr>
          <a:xfrm>
            <a:off x="303712" y="699568"/>
            <a:ext cx="6057900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Intraperitoneal </a:t>
            </a:r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insulin 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tolerance test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Intraperitoneal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insulin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tolerance tests (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IPITT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) were conducted one week prior to endpoint. Prior to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IPITT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, mice were fasted for 5 hours and had their baseline blood glucose level recorded. At time 0, a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0.16U insulin (Humalog®, Lilly)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was injected via a single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i.p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bolus, after which blood glucose measurements were obtained via tail vein bleeds at 15, 30, 45, 60, 90 and 120 minutes. Area-under-the-curve (AUC) was calculated to determine the rate of glucose clearance.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8075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5</TotalTime>
  <Words>2160</Words>
  <Application>Microsoft Office PowerPoint</Application>
  <PresentationFormat>A4 Paper (210x297 mm)</PresentationFormat>
  <Paragraphs>28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aker ID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chel Tate</dc:creator>
  <cp:lastModifiedBy>Darnel Prakoso</cp:lastModifiedBy>
  <cp:revision>169</cp:revision>
  <cp:lastPrinted>2019-08-15T04:35:40Z</cp:lastPrinted>
  <dcterms:created xsi:type="dcterms:W3CDTF">2018-11-26T04:26:02Z</dcterms:created>
  <dcterms:modified xsi:type="dcterms:W3CDTF">2019-10-18T00:52:45Z</dcterms:modified>
</cp:coreProperties>
</file>